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302" r:id="rId2"/>
    <p:sldId id="305" r:id="rId3"/>
    <p:sldId id="329" r:id="rId4"/>
    <p:sldId id="276" r:id="rId5"/>
    <p:sldId id="358" r:id="rId6"/>
    <p:sldId id="354" r:id="rId7"/>
  </p:sldIdLst>
  <p:sldSz cx="9144000" cy="6858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959" autoAdjust="0"/>
    <p:restoredTop sz="85269" autoAdjust="0"/>
  </p:normalViewPr>
  <p:slideViewPr>
    <p:cSldViewPr snapToGrid="0">
      <p:cViewPr varScale="1">
        <p:scale>
          <a:sx n="86" d="100"/>
          <a:sy n="86" d="100"/>
        </p:scale>
        <p:origin x="156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D3615C-7D75-46A1-A753-443E53561414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85C212-9794-4526-A4DA-E47ADFC049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884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223B-7215-4B7D-8DD6-D857577473C1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8F9E-B278-40C0-95E5-F6F3477D05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5169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223B-7215-4B7D-8DD6-D857577473C1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8F9E-B278-40C0-95E5-F6F3477D05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8265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223B-7215-4B7D-8DD6-D857577473C1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8F9E-B278-40C0-95E5-F6F3477D05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2523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223B-7215-4B7D-8DD6-D857577473C1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8F9E-B278-40C0-95E5-F6F3477D05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5038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223B-7215-4B7D-8DD6-D857577473C1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8F9E-B278-40C0-95E5-F6F3477D05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7608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223B-7215-4B7D-8DD6-D857577473C1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8F9E-B278-40C0-95E5-F6F3477D05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2382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223B-7215-4B7D-8DD6-D857577473C1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8F9E-B278-40C0-95E5-F6F3477D05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7196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223B-7215-4B7D-8DD6-D857577473C1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8F9E-B278-40C0-95E5-F6F3477D05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1570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223B-7215-4B7D-8DD6-D857577473C1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8F9E-B278-40C0-95E5-F6F3477D05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387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223B-7215-4B7D-8DD6-D857577473C1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8F9E-B278-40C0-95E5-F6F3477D05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1970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223B-7215-4B7D-8DD6-D857577473C1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38F9E-B278-40C0-95E5-F6F3477D05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8332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32223B-7215-4B7D-8DD6-D857577473C1}" type="datetimeFigureOut">
              <a:rPr kumimoji="1" lang="ja-JP" altLang="en-US" smtClean="0"/>
              <a:t>2023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638F9E-B278-40C0-95E5-F6F3477D05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78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5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12" Type="http://schemas.openxmlformats.org/officeDocument/2006/relationships/image" Target="../media/image14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21.png"/><Relationship Id="rId4" Type="http://schemas.openxmlformats.org/officeDocument/2006/relationships/image" Target="../media/image18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1EEACDA-0A10-43BC-842F-8B7EE1437A41}"/>
              </a:ext>
            </a:extLst>
          </p:cNvPr>
          <p:cNvSpPr txBox="1"/>
          <p:nvPr/>
        </p:nvSpPr>
        <p:spPr>
          <a:xfrm>
            <a:off x="2451002" y="3167390"/>
            <a:ext cx="424199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/>
              <a:t>Supplementally information</a:t>
            </a:r>
            <a:endParaRPr kumimoji="1" lang="ja-JP" altLang="en-US" sz="2800" dirty="0"/>
          </a:p>
        </p:txBody>
      </p:sp>
    </p:spTree>
    <p:extLst>
      <p:ext uri="{BB962C8B-B14F-4D97-AF65-F5344CB8AC3E}">
        <p14:creationId xmlns:p14="http://schemas.microsoft.com/office/powerpoint/2010/main" val="29607367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AFB3BF1A-F295-482C-94A0-1FEE06E25336}"/>
              </a:ext>
            </a:extLst>
          </p:cNvPr>
          <p:cNvGrpSpPr>
            <a:grpSpLocks noChangeAspect="1"/>
          </p:cNvGrpSpPr>
          <p:nvPr/>
        </p:nvGrpSpPr>
        <p:grpSpPr>
          <a:xfrm>
            <a:off x="487861" y="815492"/>
            <a:ext cx="4500297" cy="4022653"/>
            <a:chOff x="2075719" y="1874274"/>
            <a:chExt cx="2725268" cy="2436019"/>
          </a:xfrm>
        </p:grpSpPr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3DDF3E8A-C121-4174-8C36-6F9D67D29A7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075719" y="1874274"/>
              <a:ext cx="2725268" cy="2212363"/>
              <a:chOff x="757971" y="243619"/>
              <a:chExt cx="4388793" cy="3562805"/>
            </a:xfrm>
          </p:grpSpPr>
          <p:sp>
            <p:nvSpPr>
              <p:cNvPr id="6" name="フリーフォーム 22">
                <a:extLst>
                  <a:ext uri="{FF2B5EF4-FFF2-40B4-BE49-F238E27FC236}">
                    <a16:creationId xmlns:a16="http://schemas.microsoft.com/office/drawing/2014/main" id="{53BF5BD7-A2C3-451E-ABB1-9D2A479DEAC4}"/>
                  </a:ext>
                </a:extLst>
              </p:cNvPr>
              <p:cNvSpPr/>
              <p:nvPr/>
            </p:nvSpPr>
            <p:spPr>
              <a:xfrm rot="16200000">
                <a:off x="1152778" y="1772733"/>
                <a:ext cx="751865" cy="1349143"/>
              </a:xfrm>
              <a:custGeom>
                <a:avLst/>
                <a:gdLst>
                  <a:gd name="connsiteX0" fmla="*/ 0 w 1008184"/>
                  <a:gd name="connsiteY0" fmla="*/ 1676400 h 1809081"/>
                  <a:gd name="connsiteX1" fmla="*/ 199292 w 1008184"/>
                  <a:gd name="connsiteY1" fmla="*/ 1805354 h 1809081"/>
                  <a:gd name="connsiteX2" fmla="*/ 527538 w 1008184"/>
                  <a:gd name="connsiteY2" fmla="*/ 1547446 h 1809081"/>
                  <a:gd name="connsiteX3" fmla="*/ 820615 w 1008184"/>
                  <a:gd name="connsiteY3" fmla="*/ 1488831 h 1809081"/>
                  <a:gd name="connsiteX4" fmla="*/ 867507 w 1008184"/>
                  <a:gd name="connsiteY4" fmla="*/ 1148862 h 1809081"/>
                  <a:gd name="connsiteX5" fmla="*/ 679938 w 1008184"/>
                  <a:gd name="connsiteY5" fmla="*/ 1207477 h 1809081"/>
                  <a:gd name="connsiteX6" fmla="*/ 328246 w 1008184"/>
                  <a:gd name="connsiteY6" fmla="*/ 1078523 h 1809081"/>
                  <a:gd name="connsiteX7" fmla="*/ 691661 w 1008184"/>
                  <a:gd name="connsiteY7" fmla="*/ 832339 h 1809081"/>
                  <a:gd name="connsiteX8" fmla="*/ 797169 w 1008184"/>
                  <a:gd name="connsiteY8" fmla="*/ 879231 h 1809081"/>
                  <a:gd name="connsiteX9" fmla="*/ 820615 w 1008184"/>
                  <a:gd name="connsiteY9" fmla="*/ 515816 h 1809081"/>
                  <a:gd name="connsiteX10" fmla="*/ 1008184 w 1008184"/>
                  <a:gd name="connsiteY10" fmla="*/ 0 h 1809081"/>
                  <a:gd name="connsiteX11" fmla="*/ 1008184 w 1008184"/>
                  <a:gd name="connsiteY11" fmla="*/ 0 h 1809081"/>
                  <a:gd name="connsiteX12" fmla="*/ 1008184 w 1008184"/>
                  <a:gd name="connsiteY12" fmla="*/ 0 h 18090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1008184" h="1809081">
                    <a:moveTo>
                      <a:pt x="0" y="1676400"/>
                    </a:moveTo>
                    <a:cubicBezTo>
                      <a:pt x="55684" y="1751623"/>
                      <a:pt x="111369" y="1826846"/>
                      <a:pt x="199292" y="1805354"/>
                    </a:cubicBezTo>
                    <a:cubicBezTo>
                      <a:pt x="287215" y="1783862"/>
                      <a:pt x="423984" y="1600200"/>
                      <a:pt x="527538" y="1547446"/>
                    </a:cubicBezTo>
                    <a:cubicBezTo>
                      <a:pt x="631092" y="1494692"/>
                      <a:pt x="763954" y="1555261"/>
                      <a:pt x="820615" y="1488831"/>
                    </a:cubicBezTo>
                    <a:cubicBezTo>
                      <a:pt x="877276" y="1422401"/>
                      <a:pt x="890953" y="1195754"/>
                      <a:pt x="867507" y="1148862"/>
                    </a:cubicBezTo>
                    <a:cubicBezTo>
                      <a:pt x="844061" y="1101970"/>
                      <a:pt x="769815" y="1219200"/>
                      <a:pt x="679938" y="1207477"/>
                    </a:cubicBezTo>
                    <a:cubicBezTo>
                      <a:pt x="590061" y="1195754"/>
                      <a:pt x="326292" y="1141046"/>
                      <a:pt x="328246" y="1078523"/>
                    </a:cubicBezTo>
                    <a:cubicBezTo>
                      <a:pt x="330200" y="1016000"/>
                      <a:pt x="613507" y="865554"/>
                      <a:pt x="691661" y="832339"/>
                    </a:cubicBezTo>
                    <a:cubicBezTo>
                      <a:pt x="769815" y="799124"/>
                      <a:pt x="775677" y="931985"/>
                      <a:pt x="797169" y="879231"/>
                    </a:cubicBezTo>
                    <a:cubicBezTo>
                      <a:pt x="818661" y="826477"/>
                      <a:pt x="785446" y="662354"/>
                      <a:pt x="820615" y="515816"/>
                    </a:cubicBezTo>
                    <a:cubicBezTo>
                      <a:pt x="855784" y="369277"/>
                      <a:pt x="1008184" y="0"/>
                      <a:pt x="1008184" y="0"/>
                    </a:cubicBezTo>
                    <a:lnTo>
                      <a:pt x="1008184" y="0"/>
                    </a:lnTo>
                    <a:lnTo>
                      <a:pt x="1008184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sp>
            <p:nvSpPr>
              <p:cNvPr id="7" name="フリーフォーム 23">
                <a:extLst>
                  <a:ext uri="{FF2B5EF4-FFF2-40B4-BE49-F238E27FC236}">
                    <a16:creationId xmlns:a16="http://schemas.microsoft.com/office/drawing/2014/main" id="{252BB8D2-19A0-4E0E-A2EF-AA5EDF9C4625}"/>
                  </a:ext>
                </a:extLst>
              </p:cNvPr>
              <p:cNvSpPr/>
              <p:nvPr/>
            </p:nvSpPr>
            <p:spPr>
              <a:xfrm rot="16200000">
                <a:off x="3310113" y="1381355"/>
                <a:ext cx="700813" cy="2482903"/>
              </a:xfrm>
              <a:custGeom>
                <a:avLst/>
                <a:gdLst>
                  <a:gd name="connsiteX0" fmla="*/ 83873 w 939728"/>
                  <a:gd name="connsiteY0" fmla="*/ 0 h 3329354"/>
                  <a:gd name="connsiteX1" fmla="*/ 306611 w 939728"/>
                  <a:gd name="connsiteY1" fmla="*/ 293077 h 3329354"/>
                  <a:gd name="connsiteX2" fmla="*/ 587965 w 939728"/>
                  <a:gd name="connsiteY2" fmla="*/ 211015 h 3329354"/>
                  <a:gd name="connsiteX3" fmla="*/ 716919 w 939728"/>
                  <a:gd name="connsiteY3" fmla="*/ 656492 h 3329354"/>
                  <a:gd name="connsiteX4" fmla="*/ 740365 w 939728"/>
                  <a:gd name="connsiteY4" fmla="*/ 1066800 h 3329354"/>
                  <a:gd name="connsiteX5" fmla="*/ 752088 w 939728"/>
                  <a:gd name="connsiteY5" fmla="*/ 1652954 h 3329354"/>
                  <a:gd name="connsiteX6" fmla="*/ 939657 w 939728"/>
                  <a:gd name="connsiteY6" fmla="*/ 1946031 h 3329354"/>
                  <a:gd name="connsiteX7" fmla="*/ 728642 w 939728"/>
                  <a:gd name="connsiteY7" fmla="*/ 1922585 h 3329354"/>
                  <a:gd name="connsiteX8" fmla="*/ 247996 w 939728"/>
                  <a:gd name="connsiteY8" fmla="*/ 2028092 h 3329354"/>
                  <a:gd name="connsiteX9" fmla="*/ 13534 w 939728"/>
                  <a:gd name="connsiteY9" fmla="*/ 2719754 h 3329354"/>
                  <a:gd name="connsiteX10" fmla="*/ 48704 w 939728"/>
                  <a:gd name="connsiteY10" fmla="*/ 3329354 h 33293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939728" h="3329354">
                    <a:moveTo>
                      <a:pt x="83873" y="0"/>
                    </a:moveTo>
                    <a:cubicBezTo>
                      <a:pt x="153234" y="128954"/>
                      <a:pt x="222596" y="257908"/>
                      <a:pt x="306611" y="293077"/>
                    </a:cubicBezTo>
                    <a:cubicBezTo>
                      <a:pt x="390626" y="328246"/>
                      <a:pt x="519580" y="150446"/>
                      <a:pt x="587965" y="211015"/>
                    </a:cubicBezTo>
                    <a:cubicBezTo>
                      <a:pt x="656350" y="271584"/>
                      <a:pt x="691519" y="513861"/>
                      <a:pt x="716919" y="656492"/>
                    </a:cubicBezTo>
                    <a:cubicBezTo>
                      <a:pt x="742319" y="799123"/>
                      <a:pt x="734504" y="900723"/>
                      <a:pt x="740365" y="1066800"/>
                    </a:cubicBezTo>
                    <a:cubicBezTo>
                      <a:pt x="746227" y="1232877"/>
                      <a:pt x="718873" y="1506416"/>
                      <a:pt x="752088" y="1652954"/>
                    </a:cubicBezTo>
                    <a:cubicBezTo>
                      <a:pt x="785303" y="1799493"/>
                      <a:pt x="943565" y="1901093"/>
                      <a:pt x="939657" y="1946031"/>
                    </a:cubicBezTo>
                    <a:cubicBezTo>
                      <a:pt x="935749" y="1990969"/>
                      <a:pt x="843919" y="1908908"/>
                      <a:pt x="728642" y="1922585"/>
                    </a:cubicBezTo>
                    <a:cubicBezTo>
                      <a:pt x="613365" y="1936262"/>
                      <a:pt x="367181" y="1895231"/>
                      <a:pt x="247996" y="2028092"/>
                    </a:cubicBezTo>
                    <a:cubicBezTo>
                      <a:pt x="128811" y="2160953"/>
                      <a:pt x="46749" y="2502877"/>
                      <a:pt x="13534" y="2719754"/>
                    </a:cubicBezTo>
                    <a:cubicBezTo>
                      <a:pt x="-19681" y="2936631"/>
                      <a:pt x="14511" y="3132992"/>
                      <a:pt x="48704" y="3329354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sp>
            <p:nvSpPr>
              <p:cNvPr id="8" name="円/楕円 24">
                <a:extLst>
                  <a:ext uri="{FF2B5EF4-FFF2-40B4-BE49-F238E27FC236}">
                    <a16:creationId xmlns:a16="http://schemas.microsoft.com/office/drawing/2014/main" id="{69AF86DC-3AB5-4436-8173-5F5BB0C54CC7}"/>
                  </a:ext>
                </a:extLst>
              </p:cNvPr>
              <p:cNvSpPr/>
              <p:nvPr/>
            </p:nvSpPr>
            <p:spPr>
              <a:xfrm rot="16200000">
                <a:off x="674916" y="1830950"/>
                <a:ext cx="323477" cy="157368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sp>
            <p:nvSpPr>
              <p:cNvPr id="9" name="円/楕円 25">
                <a:extLst>
                  <a:ext uri="{FF2B5EF4-FFF2-40B4-BE49-F238E27FC236}">
                    <a16:creationId xmlns:a16="http://schemas.microsoft.com/office/drawing/2014/main" id="{D36D29C0-D905-4E7E-98CD-538AB36766F6}"/>
                  </a:ext>
                </a:extLst>
              </p:cNvPr>
              <p:cNvSpPr/>
              <p:nvPr/>
            </p:nvSpPr>
            <p:spPr>
              <a:xfrm rot="16200000">
                <a:off x="818515" y="1901784"/>
                <a:ext cx="34095" cy="96169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sp>
            <p:nvSpPr>
              <p:cNvPr id="10" name="円/楕円 26">
                <a:extLst>
                  <a:ext uri="{FF2B5EF4-FFF2-40B4-BE49-F238E27FC236}">
                    <a16:creationId xmlns:a16="http://schemas.microsoft.com/office/drawing/2014/main" id="{ACA91CE4-598D-4026-9722-18489A3E9F45}"/>
                  </a:ext>
                </a:extLst>
              </p:cNvPr>
              <p:cNvSpPr/>
              <p:nvPr/>
            </p:nvSpPr>
            <p:spPr>
              <a:xfrm rot="16200000">
                <a:off x="818515" y="1809441"/>
                <a:ext cx="34095" cy="96169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sp>
            <p:nvSpPr>
              <p:cNvPr id="11" name="フリーフォーム 27">
                <a:extLst>
                  <a:ext uri="{FF2B5EF4-FFF2-40B4-BE49-F238E27FC236}">
                    <a16:creationId xmlns:a16="http://schemas.microsoft.com/office/drawing/2014/main" id="{AA62F4EF-CAA4-4620-9576-6835AC57A85A}"/>
                  </a:ext>
                </a:extLst>
              </p:cNvPr>
              <p:cNvSpPr/>
              <p:nvPr/>
            </p:nvSpPr>
            <p:spPr>
              <a:xfrm rot="16200000" flipH="1">
                <a:off x="1140259" y="697392"/>
                <a:ext cx="751865" cy="1349143"/>
              </a:xfrm>
              <a:custGeom>
                <a:avLst/>
                <a:gdLst>
                  <a:gd name="connsiteX0" fmla="*/ 0 w 1008184"/>
                  <a:gd name="connsiteY0" fmla="*/ 1676400 h 1809081"/>
                  <a:gd name="connsiteX1" fmla="*/ 199292 w 1008184"/>
                  <a:gd name="connsiteY1" fmla="*/ 1805354 h 1809081"/>
                  <a:gd name="connsiteX2" fmla="*/ 527538 w 1008184"/>
                  <a:gd name="connsiteY2" fmla="*/ 1547446 h 1809081"/>
                  <a:gd name="connsiteX3" fmla="*/ 820615 w 1008184"/>
                  <a:gd name="connsiteY3" fmla="*/ 1488831 h 1809081"/>
                  <a:gd name="connsiteX4" fmla="*/ 867507 w 1008184"/>
                  <a:gd name="connsiteY4" fmla="*/ 1148862 h 1809081"/>
                  <a:gd name="connsiteX5" fmla="*/ 679938 w 1008184"/>
                  <a:gd name="connsiteY5" fmla="*/ 1207477 h 1809081"/>
                  <a:gd name="connsiteX6" fmla="*/ 328246 w 1008184"/>
                  <a:gd name="connsiteY6" fmla="*/ 1078523 h 1809081"/>
                  <a:gd name="connsiteX7" fmla="*/ 691661 w 1008184"/>
                  <a:gd name="connsiteY7" fmla="*/ 832339 h 1809081"/>
                  <a:gd name="connsiteX8" fmla="*/ 797169 w 1008184"/>
                  <a:gd name="connsiteY8" fmla="*/ 879231 h 1809081"/>
                  <a:gd name="connsiteX9" fmla="*/ 820615 w 1008184"/>
                  <a:gd name="connsiteY9" fmla="*/ 515816 h 1809081"/>
                  <a:gd name="connsiteX10" fmla="*/ 1008184 w 1008184"/>
                  <a:gd name="connsiteY10" fmla="*/ 0 h 1809081"/>
                  <a:gd name="connsiteX11" fmla="*/ 1008184 w 1008184"/>
                  <a:gd name="connsiteY11" fmla="*/ 0 h 1809081"/>
                  <a:gd name="connsiteX12" fmla="*/ 1008184 w 1008184"/>
                  <a:gd name="connsiteY12" fmla="*/ 0 h 18090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1008184" h="1809081">
                    <a:moveTo>
                      <a:pt x="0" y="1676400"/>
                    </a:moveTo>
                    <a:cubicBezTo>
                      <a:pt x="55684" y="1751623"/>
                      <a:pt x="111369" y="1826846"/>
                      <a:pt x="199292" y="1805354"/>
                    </a:cubicBezTo>
                    <a:cubicBezTo>
                      <a:pt x="287215" y="1783862"/>
                      <a:pt x="423984" y="1600200"/>
                      <a:pt x="527538" y="1547446"/>
                    </a:cubicBezTo>
                    <a:cubicBezTo>
                      <a:pt x="631092" y="1494692"/>
                      <a:pt x="763954" y="1555261"/>
                      <a:pt x="820615" y="1488831"/>
                    </a:cubicBezTo>
                    <a:cubicBezTo>
                      <a:pt x="877276" y="1422401"/>
                      <a:pt x="890953" y="1195754"/>
                      <a:pt x="867507" y="1148862"/>
                    </a:cubicBezTo>
                    <a:cubicBezTo>
                      <a:pt x="844061" y="1101970"/>
                      <a:pt x="769815" y="1219200"/>
                      <a:pt x="679938" y="1207477"/>
                    </a:cubicBezTo>
                    <a:cubicBezTo>
                      <a:pt x="590061" y="1195754"/>
                      <a:pt x="326292" y="1141046"/>
                      <a:pt x="328246" y="1078523"/>
                    </a:cubicBezTo>
                    <a:cubicBezTo>
                      <a:pt x="330200" y="1016000"/>
                      <a:pt x="613507" y="865554"/>
                      <a:pt x="691661" y="832339"/>
                    </a:cubicBezTo>
                    <a:cubicBezTo>
                      <a:pt x="769815" y="799124"/>
                      <a:pt x="775677" y="931985"/>
                      <a:pt x="797169" y="879231"/>
                    </a:cubicBezTo>
                    <a:cubicBezTo>
                      <a:pt x="818661" y="826477"/>
                      <a:pt x="785446" y="662354"/>
                      <a:pt x="820615" y="515816"/>
                    </a:cubicBezTo>
                    <a:cubicBezTo>
                      <a:pt x="855784" y="369277"/>
                      <a:pt x="1008184" y="0"/>
                      <a:pt x="1008184" y="0"/>
                    </a:cubicBezTo>
                    <a:lnTo>
                      <a:pt x="1008184" y="0"/>
                    </a:lnTo>
                    <a:lnTo>
                      <a:pt x="1008184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sp>
            <p:nvSpPr>
              <p:cNvPr id="12" name="フリーフォーム 28">
                <a:extLst>
                  <a:ext uri="{FF2B5EF4-FFF2-40B4-BE49-F238E27FC236}">
                    <a16:creationId xmlns:a16="http://schemas.microsoft.com/office/drawing/2014/main" id="{361B0339-FB83-4A64-B52D-28536C9F7718}"/>
                  </a:ext>
                </a:extLst>
              </p:cNvPr>
              <p:cNvSpPr/>
              <p:nvPr/>
            </p:nvSpPr>
            <p:spPr>
              <a:xfrm rot="16200000" flipH="1">
                <a:off x="3336341" y="-111576"/>
                <a:ext cx="700813" cy="2482903"/>
              </a:xfrm>
              <a:custGeom>
                <a:avLst/>
                <a:gdLst>
                  <a:gd name="connsiteX0" fmla="*/ 83873 w 939728"/>
                  <a:gd name="connsiteY0" fmla="*/ 0 h 3329354"/>
                  <a:gd name="connsiteX1" fmla="*/ 306611 w 939728"/>
                  <a:gd name="connsiteY1" fmla="*/ 293077 h 3329354"/>
                  <a:gd name="connsiteX2" fmla="*/ 587965 w 939728"/>
                  <a:gd name="connsiteY2" fmla="*/ 211015 h 3329354"/>
                  <a:gd name="connsiteX3" fmla="*/ 716919 w 939728"/>
                  <a:gd name="connsiteY3" fmla="*/ 656492 h 3329354"/>
                  <a:gd name="connsiteX4" fmla="*/ 740365 w 939728"/>
                  <a:gd name="connsiteY4" fmla="*/ 1066800 h 3329354"/>
                  <a:gd name="connsiteX5" fmla="*/ 752088 w 939728"/>
                  <a:gd name="connsiteY5" fmla="*/ 1652954 h 3329354"/>
                  <a:gd name="connsiteX6" fmla="*/ 939657 w 939728"/>
                  <a:gd name="connsiteY6" fmla="*/ 1946031 h 3329354"/>
                  <a:gd name="connsiteX7" fmla="*/ 728642 w 939728"/>
                  <a:gd name="connsiteY7" fmla="*/ 1922585 h 3329354"/>
                  <a:gd name="connsiteX8" fmla="*/ 247996 w 939728"/>
                  <a:gd name="connsiteY8" fmla="*/ 2028092 h 3329354"/>
                  <a:gd name="connsiteX9" fmla="*/ 13534 w 939728"/>
                  <a:gd name="connsiteY9" fmla="*/ 2719754 h 3329354"/>
                  <a:gd name="connsiteX10" fmla="*/ 48704 w 939728"/>
                  <a:gd name="connsiteY10" fmla="*/ 3329354 h 33293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939728" h="3329354">
                    <a:moveTo>
                      <a:pt x="83873" y="0"/>
                    </a:moveTo>
                    <a:cubicBezTo>
                      <a:pt x="153234" y="128954"/>
                      <a:pt x="222596" y="257908"/>
                      <a:pt x="306611" y="293077"/>
                    </a:cubicBezTo>
                    <a:cubicBezTo>
                      <a:pt x="390626" y="328246"/>
                      <a:pt x="519580" y="150446"/>
                      <a:pt x="587965" y="211015"/>
                    </a:cubicBezTo>
                    <a:cubicBezTo>
                      <a:pt x="656350" y="271584"/>
                      <a:pt x="691519" y="513861"/>
                      <a:pt x="716919" y="656492"/>
                    </a:cubicBezTo>
                    <a:cubicBezTo>
                      <a:pt x="742319" y="799123"/>
                      <a:pt x="734504" y="900723"/>
                      <a:pt x="740365" y="1066800"/>
                    </a:cubicBezTo>
                    <a:cubicBezTo>
                      <a:pt x="746227" y="1232877"/>
                      <a:pt x="718873" y="1506416"/>
                      <a:pt x="752088" y="1652954"/>
                    </a:cubicBezTo>
                    <a:cubicBezTo>
                      <a:pt x="785303" y="1799493"/>
                      <a:pt x="943565" y="1901093"/>
                      <a:pt x="939657" y="1946031"/>
                    </a:cubicBezTo>
                    <a:cubicBezTo>
                      <a:pt x="935749" y="1990969"/>
                      <a:pt x="843919" y="1908908"/>
                      <a:pt x="728642" y="1922585"/>
                    </a:cubicBezTo>
                    <a:cubicBezTo>
                      <a:pt x="613365" y="1936262"/>
                      <a:pt x="367181" y="1895231"/>
                      <a:pt x="247996" y="2028092"/>
                    </a:cubicBezTo>
                    <a:cubicBezTo>
                      <a:pt x="128811" y="2160953"/>
                      <a:pt x="46749" y="2502877"/>
                      <a:pt x="13534" y="2719754"/>
                    </a:cubicBezTo>
                    <a:cubicBezTo>
                      <a:pt x="-19681" y="2936631"/>
                      <a:pt x="14511" y="3132992"/>
                      <a:pt x="48704" y="3329354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grpSp>
            <p:nvGrpSpPr>
              <p:cNvPr id="13" name="グループ化 12">
                <a:extLst>
                  <a:ext uri="{FF2B5EF4-FFF2-40B4-BE49-F238E27FC236}">
                    <a16:creationId xmlns:a16="http://schemas.microsoft.com/office/drawing/2014/main" id="{B7451FE3-52D7-4C5E-8E35-AD17F0369C62}"/>
                  </a:ext>
                </a:extLst>
              </p:cNvPr>
              <p:cNvGrpSpPr/>
              <p:nvPr/>
            </p:nvGrpSpPr>
            <p:grpSpPr>
              <a:xfrm>
                <a:off x="2072636" y="1381125"/>
                <a:ext cx="1177170" cy="991393"/>
                <a:chOff x="2072636" y="1441044"/>
                <a:chExt cx="959189" cy="931474"/>
              </a:xfrm>
            </p:grpSpPr>
            <p:sp>
              <p:nvSpPr>
                <p:cNvPr id="59" name="フリーフォーム 76">
                  <a:extLst>
                    <a:ext uri="{FF2B5EF4-FFF2-40B4-BE49-F238E27FC236}">
                      <a16:creationId xmlns:a16="http://schemas.microsoft.com/office/drawing/2014/main" id="{FC78996A-CCBD-46FE-AE22-07B6E3588364}"/>
                    </a:ext>
                  </a:extLst>
                </p:cNvPr>
                <p:cNvSpPr/>
                <p:nvPr/>
              </p:nvSpPr>
              <p:spPr>
                <a:xfrm rot="16200000">
                  <a:off x="2294015" y="1634708"/>
                  <a:ext cx="516433" cy="959187"/>
                </a:xfrm>
                <a:custGeom>
                  <a:avLst/>
                  <a:gdLst>
                    <a:gd name="connsiteX0" fmla="*/ 692491 w 692491"/>
                    <a:gd name="connsiteY0" fmla="*/ 7332 h 1286185"/>
                    <a:gd name="connsiteX1" fmla="*/ 606766 w 692491"/>
                    <a:gd name="connsiteY1" fmla="*/ 7332 h 1286185"/>
                    <a:gd name="connsiteX2" fmla="*/ 425791 w 692491"/>
                    <a:gd name="connsiteY2" fmla="*/ 83532 h 1286185"/>
                    <a:gd name="connsiteX3" fmla="*/ 225766 w 692491"/>
                    <a:gd name="connsiteY3" fmla="*/ 426432 h 1286185"/>
                    <a:gd name="connsiteX4" fmla="*/ 25741 w 692491"/>
                    <a:gd name="connsiteY4" fmla="*/ 855057 h 1286185"/>
                    <a:gd name="connsiteX5" fmla="*/ 6691 w 692491"/>
                    <a:gd name="connsiteY5" fmla="*/ 1197957 h 1286185"/>
                    <a:gd name="connsiteX6" fmla="*/ 63841 w 692491"/>
                    <a:gd name="connsiteY6" fmla="*/ 1283682 h 1286185"/>
                    <a:gd name="connsiteX7" fmla="*/ 301966 w 692491"/>
                    <a:gd name="connsiteY7" fmla="*/ 1131282 h 1286185"/>
                    <a:gd name="connsiteX8" fmla="*/ 654391 w 692491"/>
                    <a:gd name="connsiteY8" fmla="*/ 1036032 h 128618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692491" h="1286185">
                      <a:moveTo>
                        <a:pt x="692491" y="7332"/>
                      </a:moveTo>
                      <a:cubicBezTo>
                        <a:pt x="671853" y="982"/>
                        <a:pt x="651216" y="-5368"/>
                        <a:pt x="606766" y="7332"/>
                      </a:cubicBezTo>
                      <a:cubicBezTo>
                        <a:pt x="562316" y="20032"/>
                        <a:pt x="489291" y="13682"/>
                        <a:pt x="425791" y="83532"/>
                      </a:cubicBezTo>
                      <a:cubicBezTo>
                        <a:pt x="362291" y="153382"/>
                        <a:pt x="292441" y="297845"/>
                        <a:pt x="225766" y="426432"/>
                      </a:cubicBezTo>
                      <a:cubicBezTo>
                        <a:pt x="159091" y="555020"/>
                        <a:pt x="62253" y="726470"/>
                        <a:pt x="25741" y="855057"/>
                      </a:cubicBezTo>
                      <a:cubicBezTo>
                        <a:pt x="-10771" y="983644"/>
                        <a:pt x="341" y="1126520"/>
                        <a:pt x="6691" y="1197957"/>
                      </a:cubicBezTo>
                      <a:cubicBezTo>
                        <a:pt x="13041" y="1269394"/>
                        <a:pt x="14629" y="1294794"/>
                        <a:pt x="63841" y="1283682"/>
                      </a:cubicBezTo>
                      <a:cubicBezTo>
                        <a:pt x="113053" y="1272570"/>
                        <a:pt x="203541" y="1172557"/>
                        <a:pt x="301966" y="1131282"/>
                      </a:cubicBezTo>
                      <a:cubicBezTo>
                        <a:pt x="400391" y="1090007"/>
                        <a:pt x="527391" y="1063019"/>
                        <a:pt x="654391" y="1036032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60" name="フリーフォーム 77">
                  <a:extLst>
                    <a:ext uri="{FF2B5EF4-FFF2-40B4-BE49-F238E27FC236}">
                      <a16:creationId xmlns:a16="http://schemas.microsoft.com/office/drawing/2014/main" id="{0DA51888-A102-486B-913B-150776A6E11C}"/>
                    </a:ext>
                  </a:extLst>
                </p:cNvPr>
                <p:cNvSpPr/>
                <p:nvPr/>
              </p:nvSpPr>
              <p:spPr>
                <a:xfrm rot="16200000" flipH="1">
                  <a:off x="2317488" y="1196192"/>
                  <a:ext cx="469484" cy="959187"/>
                </a:xfrm>
                <a:custGeom>
                  <a:avLst/>
                  <a:gdLst>
                    <a:gd name="connsiteX0" fmla="*/ 692491 w 692491"/>
                    <a:gd name="connsiteY0" fmla="*/ 7332 h 1286185"/>
                    <a:gd name="connsiteX1" fmla="*/ 606766 w 692491"/>
                    <a:gd name="connsiteY1" fmla="*/ 7332 h 1286185"/>
                    <a:gd name="connsiteX2" fmla="*/ 425791 w 692491"/>
                    <a:gd name="connsiteY2" fmla="*/ 83532 h 1286185"/>
                    <a:gd name="connsiteX3" fmla="*/ 225766 w 692491"/>
                    <a:gd name="connsiteY3" fmla="*/ 426432 h 1286185"/>
                    <a:gd name="connsiteX4" fmla="*/ 25741 w 692491"/>
                    <a:gd name="connsiteY4" fmla="*/ 855057 h 1286185"/>
                    <a:gd name="connsiteX5" fmla="*/ 6691 w 692491"/>
                    <a:gd name="connsiteY5" fmla="*/ 1197957 h 1286185"/>
                    <a:gd name="connsiteX6" fmla="*/ 63841 w 692491"/>
                    <a:gd name="connsiteY6" fmla="*/ 1283682 h 1286185"/>
                    <a:gd name="connsiteX7" fmla="*/ 301966 w 692491"/>
                    <a:gd name="connsiteY7" fmla="*/ 1131282 h 1286185"/>
                    <a:gd name="connsiteX8" fmla="*/ 654391 w 692491"/>
                    <a:gd name="connsiteY8" fmla="*/ 1036032 h 128618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692491" h="1286185">
                      <a:moveTo>
                        <a:pt x="692491" y="7332"/>
                      </a:moveTo>
                      <a:cubicBezTo>
                        <a:pt x="671853" y="982"/>
                        <a:pt x="651216" y="-5368"/>
                        <a:pt x="606766" y="7332"/>
                      </a:cubicBezTo>
                      <a:cubicBezTo>
                        <a:pt x="562316" y="20032"/>
                        <a:pt x="489291" y="13682"/>
                        <a:pt x="425791" y="83532"/>
                      </a:cubicBezTo>
                      <a:cubicBezTo>
                        <a:pt x="362291" y="153382"/>
                        <a:pt x="292441" y="297845"/>
                        <a:pt x="225766" y="426432"/>
                      </a:cubicBezTo>
                      <a:cubicBezTo>
                        <a:pt x="159091" y="555020"/>
                        <a:pt x="62253" y="726470"/>
                        <a:pt x="25741" y="855057"/>
                      </a:cubicBezTo>
                      <a:cubicBezTo>
                        <a:pt x="-10771" y="983644"/>
                        <a:pt x="341" y="1126520"/>
                        <a:pt x="6691" y="1197957"/>
                      </a:cubicBezTo>
                      <a:cubicBezTo>
                        <a:pt x="13041" y="1269394"/>
                        <a:pt x="14629" y="1294794"/>
                        <a:pt x="63841" y="1283682"/>
                      </a:cubicBezTo>
                      <a:cubicBezTo>
                        <a:pt x="113053" y="1272570"/>
                        <a:pt x="203541" y="1172557"/>
                        <a:pt x="301966" y="1131282"/>
                      </a:cubicBezTo>
                      <a:cubicBezTo>
                        <a:pt x="400391" y="1090007"/>
                        <a:pt x="527391" y="1063019"/>
                        <a:pt x="654391" y="1036032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</p:grpSp>
          <p:sp>
            <p:nvSpPr>
              <p:cNvPr id="14" name="正方形/長方形 13">
                <a:extLst>
                  <a:ext uri="{FF2B5EF4-FFF2-40B4-BE49-F238E27FC236}">
                    <a16:creationId xmlns:a16="http://schemas.microsoft.com/office/drawing/2014/main" id="{5A082A29-6A88-4479-BC36-852960F147AF}"/>
                  </a:ext>
                </a:extLst>
              </p:cNvPr>
              <p:cNvSpPr/>
              <p:nvPr/>
            </p:nvSpPr>
            <p:spPr>
              <a:xfrm rot="16200000">
                <a:off x="2885978" y="1044388"/>
                <a:ext cx="3061555" cy="146001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8400CDA1-57B4-4BBA-A5E9-A3DBEF5C0F6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 rot="16200000">
                <a:off x="2432181" y="1472329"/>
                <a:ext cx="515190" cy="752491"/>
                <a:chOff x="4903567" y="2476500"/>
                <a:chExt cx="1537388" cy="2245523"/>
              </a:xfrm>
            </p:grpSpPr>
            <p:sp>
              <p:nvSpPr>
                <p:cNvPr id="37" name="フリーフォーム 54">
                  <a:extLst>
                    <a:ext uri="{FF2B5EF4-FFF2-40B4-BE49-F238E27FC236}">
                      <a16:creationId xmlns:a16="http://schemas.microsoft.com/office/drawing/2014/main" id="{0CA42278-D809-48D8-B7C8-C4C8FADCD62E}"/>
                    </a:ext>
                  </a:extLst>
                </p:cNvPr>
                <p:cNvSpPr/>
                <p:nvPr/>
              </p:nvSpPr>
              <p:spPr>
                <a:xfrm>
                  <a:off x="4903567" y="2495550"/>
                  <a:ext cx="1537388" cy="1999244"/>
                </a:xfrm>
                <a:custGeom>
                  <a:avLst/>
                  <a:gdLst>
                    <a:gd name="connsiteX0" fmla="*/ 78008 w 1537388"/>
                    <a:gd name="connsiteY0" fmla="*/ 0 h 1999244"/>
                    <a:gd name="connsiteX1" fmla="*/ 106583 w 1537388"/>
                    <a:gd name="connsiteY1" fmla="*/ 457200 h 1999244"/>
                    <a:gd name="connsiteX2" fmla="*/ 116108 w 1537388"/>
                    <a:gd name="connsiteY2" fmla="*/ 723900 h 1999244"/>
                    <a:gd name="connsiteX3" fmla="*/ 1808 w 1537388"/>
                    <a:gd name="connsiteY3" fmla="*/ 1181100 h 1999244"/>
                    <a:gd name="connsiteX4" fmla="*/ 68483 w 1537388"/>
                    <a:gd name="connsiteY4" fmla="*/ 1495425 h 1999244"/>
                    <a:gd name="connsiteX5" fmla="*/ 344708 w 1537388"/>
                    <a:gd name="connsiteY5" fmla="*/ 1762125 h 1999244"/>
                    <a:gd name="connsiteX6" fmla="*/ 868583 w 1537388"/>
                    <a:gd name="connsiteY6" fmla="*/ 1971675 h 1999244"/>
                    <a:gd name="connsiteX7" fmla="*/ 1221008 w 1537388"/>
                    <a:gd name="connsiteY7" fmla="*/ 1990725 h 1999244"/>
                    <a:gd name="connsiteX8" fmla="*/ 1468658 w 1537388"/>
                    <a:gd name="connsiteY8" fmla="*/ 1914525 h 1999244"/>
                    <a:gd name="connsiteX9" fmla="*/ 1535333 w 1537388"/>
                    <a:gd name="connsiteY9" fmla="*/ 1533525 h 1999244"/>
                    <a:gd name="connsiteX10" fmla="*/ 1411508 w 1537388"/>
                    <a:gd name="connsiteY10" fmla="*/ 1076325 h 1999244"/>
                    <a:gd name="connsiteX11" fmla="*/ 1163858 w 1537388"/>
                    <a:gd name="connsiteY11" fmla="*/ 666750 h 1999244"/>
                    <a:gd name="connsiteX12" fmla="*/ 897158 w 1537388"/>
                    <a:gd name="connsiteY12" fmla="*/ 571500 h 1999244"/>
                    <a:gd name="connsiteX13" fmla="*/ 792383 w 1537388"/>
                    <a:gd name="connsiteY13" fmla="*/ 619125 h 199924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</a:cxnLst>
                  <a:rect l="l" t="t" r="r" b="b"/>
                  <a:pathLst>
                    <a:path w="1537388" h="1999244">
                      <a:moveTo>
                        <a:pt x="78008" y="0"/>
                      </a:moveTo>
                      <a:cubicBezTo>
                        <a:pt x="89120" y="168275"/>
                        <a:pt x="100233" y="336550"/>
                        <a:pt x="106583" y="457200"/>
                      </a:cubicBezTo>
                      <a:cubicBezTo>
                        <a:pt x="112933" y="577850"/>
                        <a:pt x="133571" y="603250"/>
                        <a:pt x="116108" y="723900"/>
                      </a:cubicBezTo>
                      <a:cubicBezTo>
                        <a:pt x="98645" y="844550"/>
                        <a:pt x="9745" y="1052513"/>
                        <a:pt x="1808" y="1181100"/>
                      </a:cubicBezTo>
                      <a:cubicBezTo>
                        <a:pt x="-6129" y="1309687"/>
                        <a:pt x="11333" y="1398588"/>
                        <a:pt x="68483" y="1495425"/>
                      </a:cubicBezTo>
                      <a:cubicBezTo>
                        <a:pt x="125633" y="1592262"/>
                        <a:pt x="211358" y="1682750"/>
                        <a:pt x="344708" y="1762125"/>
                      </a:cubicBezTo>
                      <a:cubicBezTo>
                        <a:pt x="478058" y="1841500"/>
                        <a:pt x="722533" y="1933575"/>
                        <a:pt x="868583" y="1971675"/>
                      </a:cubicBezTo>
                      <a:cubicBezTo>
                        <a:pt x="1014633" y="2009775"/>
                        <a:pt x="1120996" y="2000250"/>
                        <a:pt x="1221008" y="1990725"/>
                      </a:cubicBezTo>
                      <a:cubicBezTo>
                        <a:pt x="1321020" y="1981200"/>
                        <a:pt x="1416271" y="1990725"/>
                        <a:pt x="1468658" y="1914525"/>
                      </a:cubicBezTo>
                      <a:cubicBezTo>
                        <a:pt x="1521045" y="1838325"/>
                        <a:pt x="1544858" y="1673225"/>
                        <a:pt x="1535333" y="1533525"/>
                      </a:cubicBezTo>
                      <a:cubicBezTo>
                        <a:pt x="1525808" y="1393825"/>
                        <a:pt x="1473420" y="1220787"/>
                        <a:pt x="1411508" y="1076325"/>
                      </a:cubicBezTo>
                      <a:cubicBezTo>
                        <a:pt x="1349596" y="931863"/>
                        <a:pt x="1249583" y="750888"/>
                        <a:pt x="1163858" y="666750"/>
                      </a:cubicBezTo>
                      <a:cubicBezTo>
                        <a:pt x="1078133" y="582613"/>
                        <a:pt x="959070" y="579437"/>
                        <a:pt x="897158" y="571500"/>
                      </a:cubicBezTo>
                      <a:cubicBezTo>
                        <a:pt x="835246" y="563563"/>
                        <a:pt x="813814" y="591344"/>
                        <a:pt x="792383" y="619125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38" name="フリーフォーム 55">
                  <a:extLst>
                    <a:ext uri="{FF2B5EF4-FFF2-40B4-BE49-F238E27FC236}">
                      <a16:creationId xmlns:a16="http://schemas.microsoft.com/office/drawing/2014/main" id="{1349BF2B-B567-4F92-A2C9-DAD950DB5378}"/>
                    </a:ext>
                  </a:extLst>
                </p:cNvPr>
                <p:cNvSpPr/>
                <p:nvPr/>
              </p:nvSpPr>
              <p:spPr>
                <a:xfrm>
                  <a:off x="5257800" y="2476500"/>
                  <a:ext cx="157305" cy="914400"/>
                </a:xfrm>
                <a:custGeom>
                  <a:avLst/>
                  <a:gdLst>
                    <a:gd name="connsiteX0" fmla="*/ 0 w 219075"/>
                    <a:gd name="connsiteY0" fmla="*/ 0 h 933450"/>
                    <a:gd name="connsiteX1" fmla="*/ 9525 w 219075"/>
                    <a:gd name="connsiteY1" fmla="*/ 400050 h 933450"/>
                    <a:gd name="connsiteX2" fmla="*/ 19050 w 219075"/>
                    <a:gd name="connsiteY2" fmla="*/ 628650 h 933450"/>
                    <a:gd name="connsiteX3" fmla="*/ 171450 w 219075"/>
                    <a:gd name="connsiteY3" fmla="*/ 866775 h 933450"/>
                    <a:gd name="connsiteX4" fmla="*/ 219075 w 219075"/>
                    <a:gd name="connsiteY4" fmla="*/ 933450 h 9334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19075" h="933450">
                      <a:moveTo>
                        <a:pt x="0" y="0"/>
                      </a:moveTo>
                      <a:cubicBezTo>
                        <a:pt x="3175" y="147637"/>
                        <a:pt x="6350" y="295275"/>
                        <a:pt x="9525" y="400050"/>
                      </a:cubicBezTo>
                      <a:cubicBezTo>
                        <a:pt x="12700" y="504825"/>
                        <a:pt x="-7937" y="550863"/>
                        <a:pt x="19050" y="628650"/>
                      </a:cubicBezTo>
                      <a:cubicBezTo>
                        <a:pt x="46037" y="706437"/>
                        <a:pt x="138113" y="815975"/>
                        <a:pt x="171450" y="866775"/>
                      </a:cubicBezTo>
                      <a:cubicBezTo>
                        <a:pt x="204787" y="917575"/>
                        <a:pt x="211931" y="925512"/>
                        <a:pt x="219075" y="933450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39" name="フリーフォーム 56">
                  <a:extLst>
                    <a:ext uri="{FF2B5EF4-FFF2-40B4-BE49-F238E27FC236}">
                      <a16:creationId xmlns:a16="http://schemas.microsoft.com/office/drawing/2014/main" id="{42CD363B-F9E5-40EA-8879-8B209CFCB76C}"/>
                    </a:ext>
                  </a:extLst>
                </p:cNvPr>
                <p:cNvSpPr/>
                <p:nvPr/>
              </p:nvSpPr>
              <p:spPr>
                <a:xfrm>
                  <a:off x="5407025" y="3038474"/>
                  <a:ext cx="61453" cy="581025"/>
                </a:xfrm>
                <a:custGeom>
                  <a:avLst/>
                  <a:gdLst>
                    <a:gd name="connsiteX0" fmla="*/ 0 w 76200"/>
                    <a:gd name="connsiteY0" fmla="*/ 590550 h 590550"/>
                    <a:gd name="connsiteX1" fmla="*/ 38100 w 76200"/>
                    <a:gd name="connsiteY1" fmla="*/ 219075 h 590550"/>
                    <a:gd name="connsiteX2" fmla="*/ 76200 w 76200"/>
                    <a:gd name="connsiteY2" fmla="*/ 0 h 5905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76200" h="590550">
                      <a:moveTo>
                        <a:pt x="0" y="590550"/>
                      </a:moveTo>
                      <a:cubicBezTo>
                        <a:pt x="12700" y="454025"/>
                        <a:pt x="25400" y="317500"/>
                        <a:pt x="38100" y="219075"/>
                      </a:cubicBezTo>
                      <a:cubicBezTo>
                        <a:pt x="50800" y="120650"/>
                        <a:pt x="63500" y="60325"/>
                        <a:pt x="76200" y="0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40" name="フリーフォーム 57">
                  <a:extLst>
                    <a:ext uri="{FF2B5EF4-FFF2-40B4-BE49-F238E27FC236}">
                      <a16:creationId xmlns:a16="http://schemas.microsoft.com/office/drawing/2014/main" id="{050E98B1-BBCB-44B0-B833-07AEA6CFC09F}"/>
                    </a:ext>
                  </a:extLst>
                </p:cNvPr>
                <p:cNvSpPr/>
                <p:nvPr/>
              </p:nvSpPr>
              <p:spPr>
                <a:xfrm>
                  <a:off x="5609408" y="2924175"/>
                  <a:ext cx="591367" cy="742950"/>
                </a:xfrm>
                <a:custGeom>
                  <a:avLst/>
                  <a:gdLst>
                    <a:gd name="connsiteX0" fmla="*/ 57967 w 591367"/>
                    <a:gd name="connsiteY0" fmla="*/ 742950 h 742950"/>
                    <a:gd name="connsiteX1" fmla="*/ 817 w 591367"/>
                    <a:gd name="connsiteY1" fmla="*/ 514350 h 742950"/>
                    <a:gd name="connsiteX2" fmla="*/ 96067 w 591367"/>
                    <a:gd name="connsiteY2" fmla="*/ 161925 h 742950"/>
                    <a:gd name="connsiteX3" fmla="*/ 286567 w 591367"/>
                    <a:gd name="connsiteY3" fmla="*/ 28575 h 742950"/>
                    <a:gd name="connsiteX4" fmla="*/ 591367 w 591367"/>
                    <a:gd name="connsiteY4" fmla="*/ 0 h 7429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591367" h="742950">
                      <a:moveTo>
                        <a:pt x="57967" y="742950"/>
                      </a:moveTo>
                      <a:cubicBezTo>
                        <a:pt x="26217" y="677068"/>
                        <a:pt x="-5533" y="611187"/>
                        <a:pt x="817" y="514350"/>
                      </a:cubicBezTo>
                      <a:cubicBezTo>
                        <a:pt x="7167" y="417513"/>
                        <a:pt x="48442" y="242887"/>
                        <a:pt x="96067" y="161925"/>
                      </a:cubicBezTo>
                      <a:cubicBezTo>
                        <a:pt x="143692" y="80962"/>
                        <a:pt x="204017" y="55563"/>
                        <a:pt x="286567" y="28575"/>
                      </a:cubicBezTo>
                      <a:cubicBezTo>
                        <a:pt x="369117" y="1587"/>
                        <a:pt x="480242" y="793"/>
                        <a:pt x="591367" y="0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41" name="フリーフォーム 58">
                  <a:extLst>
                    <a:ext uri="{FF2B5EF4-FFF2-40B4-BE49-F238E27FC236}">
                      <a16:creationId xmlns:a16="http://schemas.microsoft.com/office/drawing/2014/main" id="{F999B121-5608-477C-9A8D-E0C8D3153B9E}"/>
                    </a:ext>
                  </a:extLst>
                </p:cNvPr>
                <p:cNvSpPr/>
                <p:nvPr/>
              </p:nvSpPr>
              <p:spPr>
                <a:xfrm>
                  <a:off x="5257800" y="2568612"/>
                  <a:ext cx="628650" cy="441288"/>
                </a:xfrm>
                <a:custGeom>
                  <a:avLst/>
                  <a:gdLst>
                    <a:gd name="connsiteX0" fmla="*/ 0 w 628650"/>
                    <a:gd name="connsiteY0" fmla="*/ 441288 h 441288"/>
                    <a:gd name="connsiteX1" fmla="*/ 95250 w 628650"/>
                    <a:gd name="connsiteY1" fmla="*/ 126963 h 441288"/>
                    <a:gd name="connsiteX2" fmla="*/ 276225 w 628650"/>
                    <a:gd name="connsiteY2" fmla="*/ 22188 h 441288"/>
                    <a:gd name="connsiteX3" fmla="*/ 523875 w 628650"/>
                    <a:gd name="connsiteY3" fmla="*/ 22188 h 441288"/>
                    <a:gd name="connsiteX4" fmla="*/ 628650 w 628650"/>
                    <a:gd name="connsiteY4" fmla="*/ 260313 h 4412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28650" h="441288">
                      <a:moveTo>
                        <a:pt x="0" y="441288"/>
                      </a:moveTo>
                      <a:cubicBezTo>
                        <a:pt x="24606" y="319050"/>
                        <a:pt x="49213" y="196813"/>
                        <a:pt x="95250" y="126963"/>
                      </a:cubicBezTo>
                      <a:cubicBezTo>
                        <a:pt x="141287" y="57113"/>
                        <a:pt x="204788" y="39650"/>
                        <a:pt x="276225" y="22188"/>
                      </a:cubicBezTo>
                      <a:cubicBezTo>
                        <a:pt x="347662" y="4726"/>
                        <a:pt x="465138" y="-17499"/>
                        <a:pt x="523875" y="22188"/>
                      </a:cubicBezTo>
                      <a:cubicBezTo>
                        <a:pt x="582612" y="61875"/>
                        <a:pt x="605631" y="161094"/>
                        <a:pt x="628650" y="260313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42" name="フリーフォーム 59">
                  <a:extLst>
                    <a:ext uri="{FF2B5EF4-FFF2-40B4-BE49-F238E27FC236}">
                      <a16:creationId xmlns:a16="http://schemas.microsoft.com/office/drawing/2014/main" id="{5EADDFC9-46D3-43B1-9F33-18C9047E76D3}"/>
                    </a:ext>
                  </a:extLst>
                </p:cNvPr>
                <p:cNvSpPr/>
                <p:nvPr/>
              </p:nvSpPr>
              <p:spPr>
                <a:xfrm>
                  <a:off x="5467350" y="2809814"/>
                  <a:ext cx="247650" cy="238186"/>
                </a:xfrm>
                <a:custGeom>
                  <a:avLst/>
                  <a:gdLst>
                    <a:gd name="connsiteX0" fmla="*/ 0 w 247650"/>
                    <a:gd name="connsiteY0" fmla="*/ 238186 h 238186"/>
                    <a:gd name="connsiteX1" fmla="*/ 47625 w 247650"/>
                    <a:gd name="connsiteY1" fmla="*/ 66736 h 238186"/>
                    <a:gd name="connsiteX2" fmla="*/ 190500 w 247650"/>
                    <a:gd name="connsiteY2" fmla="*/ 61 h 238186"/>
                    <a:gd name="connsiteX3" fmla="*/ 247650 w 247650"/>
                    <a:gd name="connsiteY3" fmla="*/ 57211 h 23818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247650" h="238186">
                      <a:moveTo>
                        <a:pt x="0" y="238186"/>
                      </a:moveTo>
                      <a:cubicBezTo>
                        <a:pt x="7937" y="172304"/>
                        <a:pt x="15875" y="106423"/>
                        <a:pt x="47625" y="66736"/>
                      </a:cubicBezTo>
                      <a:cubicBezTo>
                        <a:pt x="79375" y="27048"/>
                        <a:pt x="157163" y="1648"/>
                        <a:pt x="190500" y="61"/>
                      </a:cubicBezTo>
                      <a:cubicBezTo>
                        <a:pt x="223837" y="-1526"/>
                        <a:pt x="235743" y="27842"/>
                        <a:pt x="247650" y="57211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43" name="フリーフォーム 60">
                  <a:extLst>
                    <a:ext uri="{FF2B5EF4-FFF2-40B4-BE49-F238E27FC236}">
                      <a16:creationId xmlns:a16="http://schemas.microsoft.com/office/drawing/2014/main" id="{3FC8B518-4781-45DC-BC54-994D5A6B83C9}"/>
                    </a:ext>
                  </a:extLst>
                </p:cNvPr>
                <p:cNvSpPr/>
                <p:nvPr/>
              </p:nvSpPr>
              <p:spPr>
                <a:xfrm>
                  <a:off x="5565775" y="2800057"/>
                  <a:ext cx="561975" cy="67225"/>
                </a:xfrm>
                <a:custGeom>
                  <a:avLst/>
                  <a:gdLst>
                    <a:gd name="connsiteX0" fmla="*/ 0 w 561975"/>
                    <a:gd name="connsiteY0" fmla="*/ 47625 h 67225"/>
                    <a:gd name="connsiteX1" fmla="*/ 95250 w 561975"/>
                    <a:gd name="connsiteY1" fmla="*/ 66675 h 67225"/>
                    <a:gd name="connsiteX2" fmla="*/ 323850 w 561975"/>
                    <a:gd name="connsiteY2" fmla="*/ 28575 h 67225"/>
                    <a:gd name="connsiteX3" fmla="*/ 561975 w 561975"/>
                    <a:gd name="connsiteY3" fmla="*/ 0 h 67225"/>
                    <a:gd name="connsiteX4" fmla="*/ 561975 w 561975"/>
                    <a:gd name="connsiteY4" fmla="*/ 0 h 672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561975" h="67225">
                      <a:moveTo>
                        <a:pt x="0" y="47625"/>
                      </a:moveTo>
                      <a:cubicBezTo>
                        <a:pt x="20637" y="58737"/>
                        <a:pt x="41275" y="69850"/>
                        <a:pt x="95250" y="66675"/>
                      </a:cubicBezTo>
                      <a:cubicBezTo>
                        <a:pt x="149225" y="63500"/>
                        <a:pt x="246063" y="39687"/>
                        <a:pt x="323850" y="28575"/>
                      </a:cubicBezTo>
                      <a:cubicBezTo>
                        <a:pt x="401638" y="17462"/>
                        <a:pt x="561975" y="0"/>
                        <a:pt x="561975" y="0"/>
                      </a:cubicBezTo>
                      <a:lnTo>
                        <a:pt x="561975" y="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44" name="フリーフォーム 61">
                  <a:extLst>
                    <a:ext uri="{FF2B5EF4-FFF2-40B4-BE49-F238E27FC236}">
                      <a16:creationId xmlns:a16="http://schemas.microsoft.com/office/drawing/2014/main" id="{6C5B05A0-22A9-4B46-BD18-654158963E4F}"/>
                    </a:ext>
                  </a:extLst>
                </p:cNvPr>
                <p:cNvSpPr/>
                <p:nvPr/>
              </p:nvSpPr>
              <p:spPr>
                <a:xfrm>
                  <a:off x="5896611" y="2955559"/>
                  <a:ext cx="45719" cy="136220"/>
                </a:xfrm>
                <a:custGeom>
                  <a:avLst/>
                  <a:gdLst>
                    <a:gd name="connsiteX0" fmla="*/ 0 w 19050"/>
                    <a:gd name="connsiteY0" fmla="*/ 0 h 190500"/>
                    <a:gd name="connsiteX1" fmla="*/ 19050 w 19050"/>
                    <a:gd name="connsiteY1" fmla="*/ 190500 h 1905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9050" h="190500">
                      <a:moveTo>
                        <a:pt x="0" y="0"/>
                      </a:moveTo>
                      <a:lnTo>
                        <a:pt x="19050" y="190500"/>
                      </a:ln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45" name="フリーフォーム 62">
                  <a:extLst>
                    <a:ext uri="{FF2B5EF4-FFF2-40B4-BE49-F238E27FC236}">
                      <a16:creationId xmlns:a16="http://schemas.microsoft.com/office/drawing/2014/main" id="{B76F8A35-CBBA-43C4-A3A0-FAFE0694F242}"/>
                    </a:ext>
                  </a:extLst>
                </p:cNvPr>
                <p:cNvSpPr/>
                <p:nvPr/>
              </p:nvSpPr>
              <p:spPr>
                <a:xfrm>
                  <a:off x="5022978" y="3319170"/>
                  <a:ext cx="1006967" cy="1023838"/>
                </a:xfrm>
                <a:custGeom>
                  <a:avLst/>
                  <a:gdLst>
                    <a:gd name="connsiteX0" fmla="*/ 58270 w 1006967"/>
                    <a:gd name="connsiteY0" fmla="*/ 0 h 1023838"/>
                    <a:gd name="connsiteX1" fmla="*/ 39220 w 1006967"/>
                    <a:gd name="connsiteY1" fmla="*/ 114300 h 1023838"/>
                    <a:gd name="connsiteX2" fmla="*/ 1120 w 1006967"/>
                    <a:gd name="connsiteY2" fmla="*/ 352425 h 1023838"/>
                    <a:gd name="connsiteX3" fmla="*/ 86845 w 1006967"/>
                    <a:gd name="connsiteY3" fmla="*/ 657225 h 1023838"/>
                    <a:gd name="connsiteX4" fmla="*/ 382120 w 1006967"/>
                    <a:gd name="connsiteY4" fmla="*/ 847725 h 1023838"/>
                    <a:gd name="connsiteX5" fmla="*/ 629770 w 1006967"/>
                    <a:gd name="connsiteY5" fmla="*/ 962025 h 1023838"/>
                    <a:gd name="connsiteX6" fmla="*/ 839320 w 1006967"/>
                    <a:gd name="connsiteY6" fmla="*/ 990600 h 1023838"/>
                    <a:gd name="connsiteX7" fmla="*/ 1001245 w 1006967"/>
                    <a:gd name="connsiteY7" fmla="*/ 1019175 h 1023838"/>
                    <a:gd name="connsiteX8" fmla="*/ 953620 w 1006967"/>
                    <a:gd name="connsiteY8" fmla="*/ 885825 h 1023838"/>
                    <a:gd name="connsiteX9" fmla="*/ 791695 w 1006967"/>
                    <a:gd name="connsiteY9" fmla="*/ 752475 h 1023838"/>
                    <a:gd name="connsiteX10" fmla="*/ 753595 w 1006967"/>
                    <a:gd name="connsiteY10" fmla="*/ 561975 h 1023838"/>
                    <a:gd name="connsiteX11" fmla="*/ 667870 w 1006967"/>
                    <a:gd name="connsiteY11" fmla="*/ 447675 h 1023838"/>
                    <a:gd name="connsiteX12" fmla="*/ 639295 w 1006967"/>
                    <a:gd name="connsiteY12" fmla="*/ 371475 h 102383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</a:cxnLst>
                  <a:rect l="l" t="t" r="r" b="b"/>
                  <a:pathLst>
                    <a:path w="1006967" h="1023838">
                      <a:moveTo>
                        <a:pt x="58270" y="0"/>
                      </a:moveTo>
                      <a:cubicBezTo>
                        <a:pt x="53507" y="28575"/>
                        <a:pt x="48745" y="55563"/>
                        <a:pt x="39220" y="114300"/>
                      </a:cubicBezTo>
                      <a:cubicBezTo>
                        <a:pt x="29695" y="173038"/>
                        <a:pt x="-6818" y="261938"/>
                        <a:pt x="1120" y="352425"/>
                      </a:cubicBezTo>
                      <a:cubicBezTo>
                        <a:pt x="9057" y="442913"/>
                        <a:pt x="23345" y="574675"/>
                        <a:pt x="86845" y="657225"/>
                      </a:cubicBezTo>
                      <a:cubicBezTo>
                        <a:pt x="150345" y="739775"/>
                        <a:pt x="291633" y="796925"/>
                        <a:pt x="382120" y="847725"/>
                      </a:cubicBezTo>
                      <a:cubicBezTo>
                        <a:pt x="472607" y="898525"/>
                        <a:pt x="553570" y="938213"/>
                        <a:pt x="629770" y="962025"/>
                      </a:cubicBezTo>
                      <a:cubicBezTo>
                        <a:pt x="705970" y="985837"/>
                        <a:pt x="777408" y="981075"/>
                        <a:pt x="839320" y="990600"/>
                      </a:cubicBezTo>
                      <a:cubicBezTo>
                        <a:pt x="901233" y="1000125"/>
                        <a:pt x="982195" y="1036637"/>
                        <a:pt x="1001245" y="1019175"/>
                      </a:cubicBezTo>
                      <a:cubicBezTo>
                        <a:pt x="1020295" y="1001713"/>
                        <a:pt x="988545" y="930275"/>
                        <a:pt x="953620" y="885825"/>
                      </a:cubicBezTo>
                      <a:cubicBezTo>
                        <a:pt x="918695" y="841375"/>
                        <a:pt x="825032" y="806450"/>
                        <a:pt x="791695" y="752475"/>
                      </a:cubicBezTo>
                      <a:cubicBezTo>
                        <a:pt x="758358" y="698500"/>
                        <a:pt x="774232" y="612775"/>
                        <a:pt x="753595" y="561975"/>
                      </a:cubicBezTo>
                      <a:cubicBezTo>
                        <a:pt x="732958" y="511175"/>
                        <a:pt x="686920" y="479425"/>
                        <a:pt x="667870" y="447675"/>
                      </a:cubicBezTo>
                      <a:cubicBezTo>
                        <a:pt x="648820" y="415925"/>
                        <a:pt x="644057" y="393700"/>
                        <a:pt x="639295" y="371475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46" name="フリーフォーム 63">
                  <a:extLst>
                    <a:ext uri="{FF2B5EF4-FFF2-40B4-BE49-F238E27FC236}">
                      <a16:creationId xmlns:a16="http://schemas.microsoft.com/office/drawing/2014/main" id="{5071AA63-DF46-4AC8-9C6F-19BB91F01F35}"/>
                    </a:ext>
                  </a:extLst>
                </p:cNvPr>
                <p:cNvSpPr/>
                <p:nvPr/>
              </p:nvSpPr>
              <p:spPr>
                <a:xfrm>
                  <a:off x="5651175" y="3143214"/>
                  <a:ext cx="553480" cy="1045106"/>
                </a:xfrm>
                <a:custGeom>
                  <a:avLst/>
                  <a:gdLst>
                    <a:gd name="connsiteX0" fmla="*/ 0 w 565855"/>
                    <a:gd name="connsiteY0" fmla="*/ 56835 h 1089205"/>
                    <a:gd name="connsiteX1" fmla="*/ 276225 w 565855"/>
                    <a:gd name="connsiteY1" fmla="*/ 9210 h 1089205"/>
                    <a:gd name="connsiteX2" fmla="*/ 438150 w 565855"/>
                    <a:gd name="connsiteY2" fmla="*/ 218760 h 1089205"/>
                    <a:gd name="connsiteX3" fmla="*/ 457200 w 565855"/>
                    <a:gd name="connsiteY3" fmla="*/ 361635 h 1089205"/>
                    <a:gd name="connsiteX4" fmla="*/ 485775 w 565855"/>
                    <a:gd name="connsiteY4" fmla="*/ 599760 h 1089205"/>
                    <a:gd name="connsiteX5" fmla="*/ 552450 w 565855"/>
                    <a:gd name="connsiteY5" fmla="*/ 818835 h 1089205"/>
                    <a:gd name="connsiteX6" fmla="*/ 561975 w 565855"/>
                    <a:gd name="connsiteY6" fmla="*/ 1018860 h 1089205"/>
                    <a:gd name="connsiteX7" fmla="*/ 504825 w 565855"/>
                    <a:gd name="connsiteY7" fmla="*/ 1085535 h 1089205"/>
                    <a:gd name="connsiteX8" fmla="*/ 381000 w 565855"/>
                    <a:gd name="connsiteY8" fmla="*/ 923610 h 1089205"/>
                    <a:gd name="connsiteX9" fmla="*/ 247650 w 565855"/>
                    <a:gd name="connsiteY9" fmla="*/ 780735 h 1089205"/>
                    <a:gd name="connsiteX10" fmla="*/ 104775 w 565855"/>
                    <a:gd name="connsiteY10" fmla="*/ 637860 h 1089205"/>
                    <a:gd name="connsiteX11" fmla="*/ 28575 w 565855"/>
                    <a:gd name="connsiteY11" fmla="*/ 542610 h 108920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</a:cxnLst>
                  <a:rect l="l" t="t" r="r" b="b"/>
                  <a:pathLst>
                    <a:path w="565855" h="1089205">
                      <a:moveTo>
                        <a:pt x="0" y="56835"/>
                      </a:moveTo>
                      <a:cubicBezTo>
                        <a:pt x="101600" y="19528"/>
                        <a:pt x="203200" y="-17778"/>
                        <a:pt x="276225" y="9210"/>
                      </a:cubicBezTo>
                      <a:cubicBezTo>
                        <a:pt x="349250" y="36197"/>
                        <a:pt x="407987" y="160022"/>
                        <a:pt x="438150" y="218760"/>
                      </a:cubicBezTo>
                      <a:cubicBezTo>
                        <a:pt x="468313" y="277498"/>
                        <a:pt x="449263" y="298135"/>
                        <a:pt x="457200" y="361635"/>
                      </a:cubicBezTo>
                      <a:cubicBezTo>
                        <a:pt x="465137" y="425135"/>
                        <a:pt x="469900" y="523560"/>
                        <a:pt x="485775" y="599760"/>
                      </a:cubicBezTo>
                      <a:cubicBezTo>
                        <a:pt x="501650" y="675960"/>
                        <a:pt x="539750" y="748985"/>
                        <a:pt x="552450" y="818835"/>
                      </a:cubicBezTo>
                      <a:cubicBezTo>
                        <a:pt x="565150" y="888685"/>
                        <a:pt x="569912" y="974410"/>
                        <a:pt x="561975" y="1018860"/>
                      </a:cubicBezTo>
                      <a:cubicBezTo>
                        <a:pt x="554038" y="1063310"/>
                        <a:pt x="534987" y="1101410"/>
                        <a:pt x="504825" y="1085535"/>
                      </a:cubicBezTo>
                      <a:cubicBezTo>
                        <a:pt x="474663" y="1069660"/>
                        <a:pt x="423862" y="974410"/>
                        <a:pt x="381000" y="923610"/>
                      </a:cubicBezTo>
                      <a:cubicBezTo>
                        <a:pt x="338138" y="872810"/>
                        <a:pt x="293688" y="828360"/>
                        <a:pt x="247650" y="780735"/>
                      </a:cubicBezTo>
                      <a:cubicBezTo>
                        <a:pt x="201613" y="733110"/>
                        <a:pt x="141287" y="677547"/>
                        <a:pt x="104775" y="637860"/>
                      </a:cubicBezTo>
                      <a:cubicBezTo>
                        <a:pt x="68263" y="598173"/>
                        <a:pt x="48419" y="570391"/>
                        <a:pt x="28575" y="542610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47" name="円弧 46">
                  <a:extLst>
                    <a:ext uri="{FF2B5EF4-FFF2-40B4-BE49-F238E27FC236}">
                      <a16:creationId xmlns:a16="http://schemas.microsoft.com/office/drawing/2014/main" id="{23BC62DA-9783-4765-9A74-7E2892250DB7}"/>
                    </a:ext>
                  </a:extLst>
                </p:cNvPr>
                <p:cNvSpPr/>
                <p:nvPr/>
              </p:nvSpPr>
              <p:spPr>
                <a:xfrm rot="18386826">
                  <a:off x="5027089" y="4011602"/>
                  <a:ext cx="544664" cy="368472"/>
                </a:xfrm>
                <a:prstGeom prst="arc">
                  <a:avLst>
                    <a:gd name="adj1" fmla="val 17155090"/>
                    <a:gd name="adj2" fmla="val 0"/>
                  </a:avLst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48" name="円/楕円 65">
                  <a:extLst>
                    <a:ext uri="{FF2B5EF4-FFF2-40B4-BE49-F238E27FC236}">
                      <a16:creationId xmlns:a16="http://schemas.microsoft.com/office/drawing/2014/main" id="{E04F21BC-4895-4095-8433-4A8C8474D328}"/>
                    </a:ext>
                  </a:extLst>
                </p:cNvPr>
                <p:cNvSpPr/>
                <p:nvPr/>
              </p:nvSpPr>
              <p:spPr>
                <a:xfrm>
                  <a:off x="5392055" y="3571073"/>
                  <a:ext cx="272956" cy="201554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49" name="円/楕円 66">
                  <a:extLst>
                    <a:ext uri="{FF2B5EF4-FFF2-40B4-BE49-F238E27FC236}">
                      <a16:creationId xmlns:a16="http://schemas.microsoft.com/office/drawing/2014/main" id="{84E7B471-F1DC-4A7C-9FF5-D657465CEAA4}"/>
                    </a:ext>
                  </a:extLst>
                </p:cNvPr>
                <p:cNvSpPr/>
                <p:nvPr/>
              </p:nvSpPr>
              <p:spPr>
                <a:xfrm rot="17271841">
                  <a:off x="5614964" y="3505375"/>
                  <a:ext cx="210286" cy="138075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50" name="フリーフォーム 67">
                  <a:extLst>
                    <a:ext uri="{FF2B5EF4-FFF2-40B4-BE49-F238E27FC236}">
                      <a16:creationId xmlns:a16="http://schemas.microsoft.com/office/drawing/2014/main" id="{369B259B-4243-407E-AEC0-03A1656FA827}"/>
                    </a:ext>
                  </a:extLst>
                </p:cNvPr>
                <p:cNvSpPr/>
                <p:nvPr/>
              </p:nvSpPr>
              <p:spPr>
                <a:xfrm>
                  <a:off x="5610226" y="3374422"/>
                  <a:ext cx="133350" cy="92678"/>
                </a:xfrm>
                <a:custGeom>
                  <a:avLst/>
                  <a:gdLst>
                    <a:gd name="connsiteX0" fmla="*/ 133350 w 133350"/>
                    <a:gd name="connsiteY0" fmla="*/ 92678 h 92678"/>
                    <a:gd name="connsiteX1" fmla="*/ 28575 w 133350"/>
                    <a:gd name="connsiteY1" fmla="*/ 11716 h 92678"/>
                    <a:gd name="connsiteX2" fmla="*/ 0 w 133350"/>
                    <a:gd name="connsiteY2" fmla="*/ 2191 h 9267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33350" h="92678">
                      <a:moveTo>
                        <a:pt x="133350" y="92678"/>
                      </a:moveTo>
                      <a:cubicBezTo>
                        <a:pt x="92075" y="59737"/>
                        <a:pt x="50800" y="26797"/>
                        <a:pt x="28575" y="11716"/>
                      </a:cubicBezTo>
                      <a:cubicBezTo>
                        <a:pt x="6350" y="-3365"/>
                        <a:pt x="3175" y="-587"/>
                        <a:pt x="0" y="2191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51" name="円/楕円 68">
                  <a:extLst>
                    <a:ext uri="{FF2B5EF4-FFF2-40B4-BE49-F238E27FC236}">
                      <a16:creationId xmlns:a16="http://schemas.microsoft.com/office/drawing/2014/main" id="{3AD5F4F5-D4AF-49BA-9FDB-11E1FB3CBEDB}"/>
                    </a:ext>
                  </a:extLst>
                </p:cNvPr>
                <p:cNvSpPr/>
                <p:nvPr/>
              </p:nvSpPr>
              <p:spPr>
                <a:xfrm rot="1698690">
                  <a:off x="5775953" y="3204173"/>
                  <a:ext cx="223958" cy="142120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52" name="円弧 51">
                  <a:extLst>
                    <a:ext uri="{FF2B5EF4-FFF2-40B4-BE49-F238E27FC236}">
                      <a16:creationId xmlns:a16="http://schemas.microsoft.com/office/drawing/2014/main" id="{133BEA5C-C3B7-433C-9E47-532BD8C85734}"/>
                    </a:ext>
                  </a:extLst>
                </p:cNvPr>
                <p:cNvSpPr/>
                <p:nvPr/>
              </p:nvSpPr>
              <p:spPr>
                <a:xfrm rot="17701139" flipH="1">
                  <a:off x="5309211" y="3554034"/>
                  <a:ext cx="544664" cy="368472"/>
                </a:xfrm>
                <a:prstGeom prst="arc">
                  <a:avLst>
                    <a:gd name="adj1" fmla="val 17155090"/>
                    <a:gd name="adj2" fmla="val 0"/>
                  </a:avLst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53" name="円弧 52">
                  <a:extLst>
                    <a:ext uri="{FF2B5EF4-FFF2-40B4-BE49-F238E27FC236}">
                      <a16:creationId xmlns:a16="http://schemas.microsoft.com/office/drawing/2014/main" id="{4B53D65E-4791-4F92-A445-C05A18BC474D}"/>
                    </a:ext>
                  </a:extLst>
                </p:cNvPr>
                <p:cNvSpPr/>
                <p:nvPr/>
              </p:nvSpPr>
              <p:spPr>
                <a:xfrm rot="20626270">
                  <a:off x="5561616" y="3481603"/>
                  <a:ext cx="420148" cy="266700"/>
                </a:xfrm>
                <a:prstGeom prst="arc">
                  <a:avLst>
                    <a:gd name="adj1" fmla="val 17155090"/>
                    <a:gd name="adj2" fmla="val 0"/>
                  </a:avLst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54" name="円弧 53">
                  <a:extLst>
                    <a:ext uri="{FF2B5EF4-FFF2-40B4-BE49-F238E27FC236}">
                      <a16:creationId xmlns:a16="http://schemas.microsoft.com/office/drawing/2014/main" id="{DA41894C-5019-4B9F-97AF-B71D3A984B07}"/>
                    </a:ext>
                  </a:extLst>
                </p:cNvPr>
                <p:cNvSpPr/>
                <p:nvPr/>
              </p:nvSpPr>
              <p:spPr>
                <a:xfrm rot="19940583" flipH="1">
                  <a:off x="5961824" y="3324731"/>
                  <a:ext cx="420148" cy="266700"/>
                </a:xfrm>
                <a:prstGeom prst="arc">
                  <a:avLst>
                    <a:gd name="adj1" fmla="val 17155090"/>
                    <a:gd name="adj2" fmla="val 0"/>
                  </a:avLst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55" name="円/楕円 72">
                  <a:extLst>
                    <a:ext uri="{FF2B5EF4-FFF2-40B4-BE49-F238E27FC236}">
                      <a16:creationId xmlns:a16="http://schemas.microsoft.com/office/drawing/2014/main" id="{C869FF84-7643-4BBE-ADF5-45D511C06340}"/>
                    </a:ext>
                  </a:extLst>
                </p:cNvPr>
                <p:cNvSpPr/>
                <p:nvPr/>
              </p:nvSpPr>
              <p:spPr>
                <a:xfrm>
                  <a:off x="5031146" y="3148227"/>
                  <a:ext cx="283900" cy="188300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56" name="円/楕円 73">
                  <a:extLst>
                    <a:ext uri="{FF2B5EF4-FFF2-40B4-BE49-F238E27FC236}">
                      <a16:creationId xmlns:a16="http://schemas.microsoft.com/office/drawing/2014/main" id="{A4EAC7F3-6DB5-4402-B781-52D9704A7A95}"/>
                    </a:ext>
                  </a:extLst>
                </p:cNvPr>
                <p:cNvSpPr/>
                <p:nvPr/>
              </p:nvSpPr>
              <p:spPr>
                <a:xfrm>
                  <a:off x="5059347" y="4533723"/>
                  <a:ext cx="283900" cy="188300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cxnSp>
              <p:nvCxnSpPr>
                <p:cNvPr id="57" name="直線コネクタ 56">
                  <a:extLst>
                    <a:ext uri="{FF2B5EF4-FFF2-40B4-BE49-F238E27FC236}">
                      <a16:creationId xmlns:a16="http://schemas.microsoft.com/office/drawing/2014/main" id="{B7C3D4E1-CF49-4303-852E-9C89FE6F8C8E}"/>
                    </a:ext>
                  </a:extLst>
                </p:cNvPr>
                <p:cNvCxnSpPr/>
                <p:nvPr/>
              </p:nvCxnSpPr>
              <p:spPr>
                <a:xfrm flipV="1">
                  <a:off x="5064109" y="4119561"/>
                  <a:ext cx="0" cy="49424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直線コネクタ 57">
                  <a:extLst>
                    <a:ext uri="{FF2B5EF4-FFF2-40B4-BE49-F238E27FC236}">
                      <a16:creationId xmlns:a16="http://schemas.microsoft.com/office/drawing/2014/main" id="{3C354AB5-D2C6-4130-851E-BDDE5617B981}"/>
                    </a:ext>
                  </a:extLst>
                </p:cNvPr>
                <p:cNvCxnSpPr/>
                <p:nvPr/>
              </p:nvCxnSpPr>
              <p:spPr>
                <a:xfrm flipV="1">
                  <a:off x="5338483" y="4326196"/>
                  <a:ext cx="19867" cy="28761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B003E482-4465-4863-B0A5-43ABDCC79CB8}"/>
                  </a:ext>
                </a:extLst>
              </p:cNvPr>
              <p:cNvSpPr txBox="1"/>
              <p:nvPr/>
            </p:nvSpPr>
            <p:spPr>
              <a:xfrm>
                <a:off x="926272" y="1712851"/>
                <a:ext cx="713171" cy="3901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2000" dirty="0"/>
                  <a:t>Head</a:t>
                </a:r>
                <a:endParaRPr kumimoji="1" lang="ja-JP" altLang="en-US" sz="2800" dirty="0"/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B3A7206A-400F-4A4D-A205-1D72009D03DC}"/>
                  </a:ext>
                </a:extLst>
              </p:cNvPr>
              <p:cNvSpPr txBox="1"/>
              <p:nvPr/>
            </p:nvSpPr>
            <p:spPr>
              <a:xfrm>
                <a:off x="3669854" y="1702595"/>
                <a:ext cx="518510" cy="3901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2000" dirty="0"/>
                  <a:t>Tail</a:t>
                </a:r>
                <a:endParaRPr kumimoji="1" lang="ja-JP" altLang="en-US" sz="2800" dirty="0"/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53932380-CABB-48D3-95FA-372705154124}"/>
                  </a:ext>
                </a:extLst>
              </p:cNvPr>
              <p:cNvSpPr txBox="1"/>
              <p:nvPr/>
            </p:nvSpPr>
            <p:spPr>
              <a:xfrm>
                <a:off x="2665746" y="1296101"/>
                <a:ext cx="364246" cy="330166"/>
              </a:xfrm>
              <a:prstGeom prst="rect">
                <a:avLst/>
              </a:prstGeom>
              <a:solidFill>
                <a:schemeClr val="bg1">
                  <a:alpha val="58000"/>
                </a:schemeClr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600" dirty="0"/>
                  <a:t>LV</a:t>
                </a:r>
                <a:endParaRPr kumimoji="1" lang="ja-JP" altLang="en-US" sz="1600" dirty="0"/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594CC31A-BB48-4051-A0C5-D7ED0B8838B8}"/>
                  </a:ext>
                </a:extLst>
              </p:cNvPr>
              <p:cNvSpPr txBox="1"/>
              <p:nvPr/>
            </p:nvSpPr>
            <p:spPr>
              <a:xfrm>
                <a:off x="2917266" y="1639594"/>
                <a:ext cx="400890" cy="330166"/>
              </a:xfrm>
              <a:prstGeom prst="rect">
                <a:avLst/>
              </a:prstGeom>
              <a:solidFill>
                <a:schemeClr val="bg1">
                  <a:alpha val="58000"/>
                </a:schemeClr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600" dirty="0"/>
                  <a:t>RV</a:t>
                </a:r>
                <a:endParaRPr kumimoji="1" lang="ja-JP" altLang="en-US" sz="1600" dirty="0"/>
              </a:p>
            </p:txBody>
          </p: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1F477DB3-855F-4AB5-B5B8-6A44D740C6D3}"/>
                  </a:ext>
                </a:extLst>
              </p:cNvPr>
              <p:cNvSpPr txBox="1"/>
              <p:nvPr/>
            </p:nvSpPr>
            <p:spPr>
              <a:xfrm>
                <a:off x="1972056" y="1596586"/>
                <a:ext cx="402077" cy="330166"/>
              </a:xfrm>
              <a:prstGeom prst="rect">
                <a:avLst/>
              </a:prstGeom>
              <a:solidFill>
                <a:schemeClr val="bg1">
                  <a:alpha val="58000"/>
                </a:schemeClr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600" dirty="0" err="1"/>
                  <a:t>Ao</a:t>
                </a:r>
                <a:endParaRPr kumimoji="1" lang="ja-JP" altLang="en-US" sz="1600" dirty="0"/>
              </a:p>
            </p:txBody>
          </p:sp>
          <p:grpSp>
            <p:nvGrpSpPr>
              <p:cNvPr id="21" name="グループ化 20">
                <a:extLst>
                  <a:ext uri="{FF2B5EF4-FFF2-40B4-BE49-F238E27FC236}">
                    <a16:creationId xmlns:a16="http://schemas.microsoft.com/office/drawing/2014/main" id="{779486F6-3312-46D5-B5B2-E069C07F0551}"/>
                  </a:ext>
                </a:extLst>
              </p:cNvPr>
              <p:cNvGrpSpPr/>
              <p:nvPr/>
            </p:nvGrpSpPr>
            <p:grpSpPr>
              <a:xfrm rot="5400000">
                <a:off x="2707015" y="3406847"/>
                <a:ext cx="312790" cy="366161"/>
                <a:chOff x="2586390" y="3905250"/>
                <a:chExt cx="544095" cy="571500"/>
              </a:xfrm>
            </p:grpSpPr>
            <p:sp>
              <p:nvSpPr>
                <p:cNvPr id="35" name="正方形/長方形 34">
                  <a:extLst>
                    <a:ext uri="{FF2B5EF4-FFF2-40B4-BE49-F238E27FC236}">
                      <a16:creationId xmlns:a16="http://schemas.microsoft.com/office/drawing/2014/main" id="{72513C7A-540B-40E5-96C1-AFFF8546648F}"/>
                    </a:ext>
                  </a:extLst>
                </p:cNvPr>
                <p:cNvSpPr/>
                <p:nvPr/>
              </p:nvSpPr>
              <p:spPr>
                <a:xfrm>
                  <a:off x="2588033" y="3905250"/>
                  <a:ext cx="542452" cy="276225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  <p:sp>
              <p:nvSpPr>
                <p:cNvPr id="36" name="正方形/長方形 35">
                  <a:extLst>
                    <a:ext uri="{FF2B5EF4-FFF2-40B4-BE49-F238E27FC236}">
                      <a16:creationId xmlns:a16="http://schemas.microsoft.com/office/drawing/2014/main" id="{55CF5A59-CC54-4586-9C1C-248C3B54EA96}"/>
                    </a:ext>
                  </a:extLst>
                </p:cNvPr>
                <p:cNvSpPr/>
                <p:nvPr/>
              </p:nvSpPr>
              <p:spPr>
                <a:xfrm>
                  <a:off x="2586390" y="4200525"/>
                  <a:ext cx="542452" cy="27622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3200"/>
                </a:p>
              </p:txBody>
            </p:sp>
          </p:grpSp>
          <p:sp>
            <p:nvSpPr>
              <p:cNvPr id="22" name="円弧 21">
                <a:extLst>
                  <a:ext uri="{FF2B5EF4-FFF2-40B4-BE49-F238E27FC236}">
                    <a16:creationId xmlns:a16="http://schemas.microsoft.com/office/drawing/2014/main" id="{54729AB5-826C-48BF-8396-8CD62EF6BDC6}"/>
                  </a:ext>
                </a:extLst>
              </p:cNvPr>
              <p:cNvSpPr/>
              <p:nvPr/>
            </p:nvSpPr>
            <p:spPr>
              <a:xfrm rot="16200000">
                <a:off x="3457867" y="3383081"/>
                <a:ext cx="421239" cy="425447"/>
              </a:xfrm>
              <a:prstGeom prst="arc">
                <a:avLst>
                  <a:gd name="adj1" fmla="val 16200000"/>
                  <a:gd name="adj2" fmla="val 5160546"/>
                </a:avLst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sp>
            <p:nvSpPr>
              <p:cNvPr id="23" name="円/楕円 39">
                <a:extLst>
                  <a:ext uri="{FF2B5EF4-FFF2-40B4-BE49-F238E27FC236}">
                    <a16:creationId xmlns:a16="http://schemas.microsoft.com/office/drawing/2014/main" id="{28AF1834-5D01-4428-B43C-65279E9E926C}"/>
                  </a:ext>
                </a:extLst>
              </p:cNvPr>
              <p:cNvSpPr/>
              <p:nvPr/>
            </p:nvSpPr>
            <p:spPr>
              <a:xfrm>
                <a:off x="3505720" y="3434242"/>
                <a:ext cx="333061" cy="341301"/>
              </a:xfrm>
              <a:prstGeom prst="ellipse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sp>
            <p:nvSpPr>
              <p:cNvPr id="24" name="円/楕円 40">
                <a:extLst>
                  <a:ext uri="{FF2B5EF4-FFF2-40B4-BE49-F238E27FC236}">
                    <a16:creationId xmlns:a16="http://schemas.microsoft.com/office/drawing/2014/main" id="{16FA856B-BF19-4A91-AF5D-BDF29D69B353}"/>
                  </a:ext>
                </a:extLst>
              </p:cNvPr>
              <p:cNvSpPr/>
              <p:nvPr/>
            </p:nvSpPr>
            <p:spPr>
              <a:xfrm>
                <a:off x="3545508" y="3536597"/>
                <a:ext cx="99438" cy="90615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sp>
            <p:nvSpPr>
              <p:cNvPr id="25" name="円/楕円 41">
                <a:extLst>
                  <a:ext uri="{FF2B5EF4-FFF2-40B4-BE49-F238E27FC236}">
                    <a16:creationId xmlns:a16="http://schemas.microsoft.com/office/drawing/2014/main" id="{DAC1D656-D940-44E0-9869-31D540E4806A}"/>
                  </a:ext>
                </a:extLst>
              </p:cNvPr>
              <p:cNvSpPr/>
              <p:nvPr/>
            </p:nvSpPr>
            <p:spPr>
              <a:xfrm>
                <a:off x="3710839" y="3536597"/>
                <a:ext cx="99438" cy="90615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cxnSp>
            <p:nvCxnSpPr>
              <p:cNvPr id="26" name="直線コネクタ 25">
                <a:extLst>
                  <a:ext uri="{FF2B5EF4-FFF2-40B4-BE49-F238E27FC236}">
                    <a16:creationId xmlns:a16="http://schemas.microsoft.com/office/drawing/2014/main" id="{9341CC8C-AD6B-4376-AA37-FA83778BA400}"/>
                  </a:ext>
                </a:extLst>
              </p:cNvPr>
              <p:cNvCxnSpPr>
                <a:cxnSpLocks/>
                <a:stCxn id="35" idx="0"/>
              </p:cNvCxnSpPr>
              <p:nvPr/>
            </p:nvCxnSpPr>
            <p:spPr>
              <a:xfrm flipV="1">
                <a:off x="3046491" y="3589454"/>
                <a:ext cx="418006" cy="947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線コネクタ 26">
                <a:extLst>
                  <a:ext uri="{FF2B5EF4-FFF2-40B4-BE49-F238E27FC236}">
                    <a16:creationId xmlns:a16="http://schemas.microsoft.com/office/drawing/2014/main" id="{5655F4C5-5B28-4A3E-8CAD-E5A64EAA25FA}"/>
                  </a:ext>
                </a:extLst>
              </p:cNvPr>
              <p:cNvCxnSpPr>
                <a:cxnSpLocks/>
                <a:stCxn id="36" idx="2"/>
              </p:cNvCxnSpPr>
              <p:nvPr/>
            </p:nvCxnSpPr>
            <p:spPr>
              <a:xfrm flipH="1" flipV="1">
                <a:off x="2501851" y="3589454"/>
                <a:ext cx="178479" cy="2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線コネクタ 27">
                <a:extLst>
                  <a:ext uri="{FF2B5EF4-FFF2-40B4-BE49-F238E27FC236}">
                    <a16:creationId xmlns:a16="http://schemas.microsoft.com/office/drawing/2014/main" id="{3B86B6D6-0931-4AC7-9258-CBD948E4B254}"/>
                  </a:ext>
                </a:extLst>
              </p:cNvPr>
              <p:cNvCxnSpPr/>
              <p:nvPr/>
            </p:nvCxnSpPr>
            <p:spPr>
              <a:xfrm flipH="1" flipV="1">
                <a:off x="2498526" y="2076803"/>
                <a:ext cx="0" cy="1519001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二等辺三角形 28">
                <a:extLst>
                  <a:ext uri="{FF2B5EF4-FFF2-40B4-BE49-F238E27FC236}">
                    <a16:creationId xmlns:a16="http://schemas.microsoft.com/office/drawing/2014/main" id="{4A7A9D57-52E7-4080-BBB2-D454097C08B4}"/>
                  </a:ext>
                </a:extLst>
              </p:cNvPr>
              <p:cNvSpPr/>
              <p:nvPr/>
            </p:nvSpPr>
            <p:spPr>
              <a:xfrm rot="20860111">
                <a:off x="2454506" y="1843483"/>
                <a:ext cx="95276" cy="207985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sp>
            <p:nvSpPr>
              <p:cNvPr id="30" name="二等辺三角形 29">
                <a:extLst>
                  <a:ext uri="{FF2B5EF4-FFF2-40B4-BE49-F238E27FC236}">
                    <a16:creationId xmlns:a16="http://schemas.microsoft.com/office/drawing/2014/main" id="{E8BEDC93-90C7-41C3-9317-9A0261A2F6AB}"/>
                  </a:ext>
                </a:extLst>
              </p:cNvPr>
              <p:cNvSpPr/>
              <p:nvPr/>
            </p:nvSpPr>
            <p:spPr>
              <a:xfrm rot="20860111">
                <a:off x="2838772" y="1907359"/>
                <a:ext cx="83823" cy="204924"/>
              </a:xfrm>
              <a:prstGeom prst="triangle">
                <a:avLst/>
              </a:prstGeom>
              <a:solidFill>
                <a:schemeClr val="accent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3200"/>
              </a:p>
            </p:txBody>
          </p:sp>
          <p:cxnSp>
            <p:nvCxnSpPr>
              <p:cNvPr id="31" name="直線コネクタ 30">
                <a:extLst>
                  <a:ext uri="{FF2B5EF4-FFF2-40B4-BE49-F238E27FC236}">
                    <a16:creationId xmlns:a16="http://schemas.microsoft.com/office/drawing/2014/main" id="{0EC3A356-B041-44BC-8EB8-0B33A1BBB4EE}"/>
                  </a:ext>
                </a:extLst>
              </p:cNvPr>
              <p:cNvCxnSpPr/>
              <p:nvPr/>
            </p:nvCxnSpPr>
            <p:spPr>
              <a:xfrm flipH="1">
                <a:off x="2887174" y="2109386"/>
                <a:ext cx="18667" cy="1079727"/>
              </a:xfrm>
              <a:prstGeom prst="line">
                <a:avLst/>
              </a:prstGeom>
              <a:ln w="254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線コネクタ 31">
                <a:extLst>
                  <a:ext uri="{FF2B5EF4-FFF2-40B4-BE49-F238E27FC236}">
                    <a16:creationId xmlns:a16="http://schemas.microsoft.com/office/drawing/2014/main" id="{FB254D52-8988-4B60-8C25-D637E87D3DDC}"/>
                  </a:ext>
                </a:extLst>
              </p:cNvPr>
              <p:cNvCxnSpPr/>
              <p:nvPr/>
            </p:nvCxnSpPr>
            <p:spPr>
              <a:xfrm>
                <a:off x="2880683" y="3189113"/>
                <a:ext cx="1195876" cy="0"/>
              </a:xfrm>
              <a:prstGeom prst="line">
                <a:avLst/>
              </a:prstGeom>
              <a:ln w="254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線コネクタ 32">
                <a:extLst>
                  <a:ext uri="{FF2B5EF4-FFF2-40B4-BE49-F238E27FC236}">
                    <a16:creationId xmlns:a16="http://schemas.microsoft.com/office/drawing/2014/main" id="{868B8DC8-CABD-4754-92E7-50DD247D8F5A}"/>
                  </a:ext>
                </a:extLst>
              </p:cNvPr>
              <p:cNvCxnSpPr/>
              <p:nvPr/>
            </p:nvCxnSpPr>
            <p:spPr>
              <a:xfrm>
                <a:off x="3881210" y="3581904"/>
                <a:ext cx="201840" cy="0"/>
              </a:xfrm>
              <a:prstGeom prst="line">
                <a:avLst/>
              </a:prstGeom>
              <a:ln w="254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id="{47580580-9A75-47CB-8DC2-33FB0FA34BCB}"/>
                  </a:ext>
                </a:extLst>
              </p:cNvPr>
              <p:cNvCxnSpPr/>
              <p:nvPr/>
            </p:nvCxnSpPr>
            <p:spPr>
              <a:xfrm flipV="1">
                <a:off x="4083050" y="3176413"/>
                <a:ext cx="0" cy="413042"/>
              </a:xfrm>
              <a:prstGeom prst="line">
                <a:avLst/>
              </a:prstGeom>
              <a:ln w="254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FEF7CEC7-7709-4385-92C4-128C9BE39BBB}"/>
                </a:ext>
              </a:extLst>
            </p:cNvPr>
            <p:cNvSpPr txBox="1"/>
            <p:nvPr/>
          </p:nvSpPr>
          <p:spPr>
            <a:xfrm>
              <a:off x="2707863" y="4042140"/>
              <a:ext cx="839572" cy="242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dirty="0"/>
                <a:t>Oxygenator</a:t>
              </a:r>
              <a:endParaRPr kumimoji="1" lang="ja-JP" altLang="en-US" sz="2000" dirty="0"/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FD529526-79AA-4F05-89FF-A4608A350816}"/>
                </a:ext>
              </a:extLst>
            </p:cNvPr>
            <p:cNvSpPr txBox="1"/>
            <p:nvPr/>
          </p:nvSpPr>
          <p:spPr>
            <a:xfrm>
              <a:off x="3697544" y="4067996"/>
              <a:ext cx="479740" cy="242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/>
                <a:t>Pump</a:t>
              </a:r>
              <a:endParaRPr kumimoji="1" lang="ja-JP" altLang="en-US" sz="2000" dirty="0"/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7B4011D1-69C7-4403-9303-7EF460201FC6}"/>
                </a:ext>
              </a:extLst>
            </p:cNvPr>
            <p:cNvSpPr txBox="1"/>
            <p:nvPr/>
          </p:nvSpPr>
          <p:spPr>
            <a:xfrm>
              <a:off x="2100140" y="3821981"/>
              <a:ext cx="434891" cy="242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/>
                <a:t>Graft</a:t>
              </a:r>
            </a:p>
          </p:txBody>
        </p:sp>
        <p:cxnSp>
          <p:nvCxnSpPr>
            <p:cNvPr id="65" name="直線矢印コネクタ 64">
              <a:extLst>
                <a:ext uri="{FF2B5EF4-FFF2-40B4-BE49-F238E27FC236}">
                  <a16:creationId xmlns:a16="http://schemas.microsoft.com/office/drawing/2014/main" id="{10659C7D-0E93-45A5-BDD3-59A1709CFC7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46969" y="3356062"/>
              <a:ext cx="810593" cy="52904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4B1B2FA8-E6A1-43FC-82B1-7A37091F85B0}"/>
                </a:ext>
              </a:extLst>
            </p:cNvPr>
            <p:cNvCxnSpPr/>
            <p:nvPr/>
          </p:nvCxnSpPr>
          <p:spPr>
            <a:xfrm>
              <a:off x="3145220" y="3343440"/>
              <a:ext cx="270000" cy="0"/>
            </a:xfrm>
            <a:prstGeom prst="line">
              <a:avLst/>
            </a:prstGeom>
            <a:ln w="317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D1E068B8-644C-44A0-9720-7AFC1022BD4C}"/>
              </a:ext>
            </a:extLst>
          </p:cNvPr>
          <p:cNvGrpSpPr>
            <a:grpSpLocks noChangeAspect="1"/>
          </p:cNvGrpSpPr>
          <p:nvPr/>
        </p:nvGrpSpPr>
        <p:grpSpPr>
          <a:xfrm>
            <a:off x="4874532" y="1453375"/>
            <a:ext cx="3647448" cy="3026886"/>
            <a:chOff x="4696198" y="2224615"/>
            <a:chExt cx="1819944" cy="1510306"/>
          </a:xfrm>
        </p:grpSpPr>
        <p:pic>
          <p:nvPicPr>
            <p:cNvPr id="63" name="Picture 2" descr="C:\Users\Atsushi\Desktop\140328_ブタ血液流し実験（1時間）\IMG_4037.JPG">
              <a:extLst>
                <a:ext uri="{FF2B5EF4-FFF2-40B4-BE49-F238E27FC236}">
                  <a16:creationId xmlns:a16="http://schemas.microsoft.com/office/drawing/2014/main" id="{91413793-A05F-4629-813E-6BDAF7B4758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19666"/>
            <a:stretch/>
          </p:blipFill>
          <p:spPr bwMode="auto">
            <a:xfrm>
              <a:off x="4696198" y="2224615"/>
              <a:ext cx="1819944" cy="1510306"/>
            </a:xfrm>
            <a:prstGeom prst="rect">
              <a:avLst/>
            </a:prstGeom>
            <a:noFill/>
          </p:spPr>
        </p:pic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8290A6BA-11C8-456C-ADDD-ECE3C9B902A3}"/>
                </a:ext>
              </a:extLst>
            </p:cNvPr>
            <p:cNvSpPr txBox="1"/>
            <p:nvPr/>
          </p:nvSpPr>
          <p:spPr>
            <a:xfrm rot="5400000">
              <a:off x="4882371" y="2723092"/>
              <a:ext cx="358328" cy="1996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/>
                <a:t>Graft</a:t>
              </a:r>
              <a:endParaRPr kumimoji="1" lang="ja-JP" altLang="en-US" sz="2000" dirty="0"/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74E375E8-1DC1-4A86-ACFB-4300441E3E4B}"/>
                </a:ext>
              </a:extLst>
            </p:cNvPr>
            <p:cNvSpPr txBox="1"/>
            <p:nvPr/>
          </p:nvSpPr>
          <p:spPr>
            <a:xfrm>
              <a:off x="5814627" y="3254738"/>
              <a:ext cx="385683" cy="1996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/>
                <a:t>Heart</a:t>
              </a:r>
              <a:endParaRPr kumimoji="1" lang="ja-JP" altLang="en-US" sz="2000" dirty="0"/>
            </a:p>
          </p:txBody>
        </p:sp>
        <p:cxnSp>
          <p:nvCxnSpPr>
            <p:cNvPr id="70" name="直線矢印コネクタ 69">
              <a:extLst>
                <a:ext uri="{FF2B5EF4-FFF2-40B4-BE49-F238E27FC236}">
                  <a16:creationId xmlns:a16="http://schemas.microsoft.com/office/drawing/2014/main" id="{1468D891-6DF4-4F96-8707-C3AE14195D3B}"/>
                </a:ext>
              </a:extLst>
            </p:cNvPr>
            <p:cNvCxnSpPr/>
            <p:nvPr/>
          </p:nvCxnSpPr>
          <p:spPr>
            <a:xfrm flipH="1" flipV="1">
              <a:off x="5061534" y="3237253"/>
              <a:ext cx="138500" cy="33474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矢印コネクタ 70">
              <a:extLst>
                <a:ext uri="{FF2B5EF4-FFF2-40B4-BE49-F238E27FC236}">
                  <a16:creationId xmlns:a16="http://schemas.microsoft.com/office/drawing/2014/main" id="{95261637-23B1-4248-96B0-30619071091F}"/>
                </a:ext>
              </a:extLst>
            </p:cNvPr>
            <p:cNvCxnSpPr/>
            <p:nvPr/>
          </p:nvCxnSpPr>
          <p:spPr>
            <a:xfrm flipV="1">
              <a:off x="5115996" y="2270578"/>
              <a:ext cx="336156" cy="17162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0D307798-E508-4F23-ABB8-2CCF0928A69E}"/>
              </a:ext>
            </a:extLst>
          </p:cNvPr>
          <p:cNvSpPr txBox="1"/>
          <p:nvPr/>
        </p:nvSpPr>
        <p:spPr>
          <a:xfrm>
            <a:off x="468612" y="5467373"/>
            <a:ext cx="79412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/>
              <a:t>Supplementary </a:t>
            </a:r>
            <a:r>
              <a:rPr lang="en-US" altLang="ja-JP" sz="1200" b="1" dirty="0"/>
              <a:t>F</a:t>
            </a:r>
            <a:r>
              <a:rPr kumimoji="1" lang="en-US" altLang="ja-JP" sz="1200" b="1" dirty="0"/>
              <a:t>igure S1. </a:t>
            </a:r>
            <a:r>
              <a:rPr lang="en-US" altLang="ja-JP" sz="1200" b="1" dirty="0"/>
              <a:t>Ex vivo blood circulation system for short-term evaluations of blood response to the graft surface by using artificial cardiopulmonary pump system. </a:t>
            </a:r>
            <a:r>
              <a:rPr lang="en-US" altLang="ja-JP" sz="1200" dirty="0"/>
              <a:t>Activated clotting time (ACT) was controlled to approximately 400 sec with heparin. The graft was connected to arterial and blood removal tube.</a:t>
            </a:r>
            <a:endParaRPr kumimoji="1" lang="en-US" altLang="ja-JP" sz="1200" dirty="0"/>
          </a:p>
        </p:txBody>
      </p:sp>
    </p:spTree>
    <p:extLst>
      <p:ext uri="{BB962C8B-B14F-4D97-AF65-F5344CB8AC3E}">
        <p14:creationId xmlns:p14="http://schemas.microsoft.com/office/powerpoint/2010/main" val="13018640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屋内, 座る, テーブル, 食品 が含まれている画像&#10;&#10;自動的に生成された説明">
            <a:extLst>
              <a:ext uri="{FF2B5EF4-FFF2-40B4-BE49-F238E27FC236}">
                <a16:creationId xmlns:a16="http://schemas.microsoft.com/office/drawing/2014/main" id="{983B9D4A-185B-4CD8-8AE2-1712B6D4981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700" y="2043639"/>
            <a:ext cx="3716216" cy="2477477"/>
          </a:xfrm>
          <a:prstGeom prst="rect">
            <a:avLst/>
          </a:prstGeom>
        </p:spPr>
      </p:pic>
      <p:pic>
        <p:nvPicPr>
          <p:cNvPr id="5" name="図 4" descr="コンピューターのスクリーンショット&#10;&#10;自動的に生成された説明">
            <a:extLst>
              <a:ext uri="{FF2B5EF4-FFF2-40B4-BE49-F238E27FC236}">
                <a16:creationId xmlns:a16="http://schemas.microsoft.com/office/drawing/2014/main" id="{8DEC57A5-A71E-47C7-AF3F-38B8D418309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2043638"/>
            <a:ext cx="3303303" cy="2477477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10C0F71-D2CF-C3FB-311F-2477F596B877}"/>
              </a:ext>
            </a:extLst>
          </p:cNvPr>
          <p:cNvSpPr txBox="1"/>
          <p:nvPr/>
        </p:nvSpPr>
        <p:spPr>
          <a:xfrm>
            <a:off x="601369" y="4871925"/>
            <a:ext cx="72739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/>
              <a:t>Supplementary Figure S2. The left-side image represents the temporary replacement of the right carotid artery. The right-side image shows the blood flow in the graft evaluated with an ultrasonic echography. </a:t>
            </a:r>
            <a:r>
              <a:rPr kumimoji="1" lang="en-US" altLang="ja-JP" sz="1200" dirty="0"/>
              <a:t>Activated clotting time (ACT) was controlled to 200 sec with heparin. The graft was connected to the right carotid artery in an end-to-end fashion.</a:t>
            </a:r>
          </a:p>
        </p:txBody>
      </p:sp>
    </p:spTree>
    <p:extLst>
      <p:ext uri="{BB962C8B-B14F-4D97-AF65-F5344CB8AC3E}">
        <p14:creationId xmlns:p14="http://schemas.microsoft.com/office/powerpoint/2010/main" val="27837898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CFA6E515-0888-472A-AB2A-BE8219488555}"/>
              </a:ext>
            </a:extLst>
          </p:cNvPr>
          <p:cNvGrpSpPr>
            <a:grpSpLocks noChangeAspect="1"/>
          </p:cNvGrpSpPr>
          <p:nvPr/>
        </p:nvGrpSpPr>
        <p:grpSpPr>
          <a:xfrm>
            <a:off x="2431395" y="1159362"/>
            <a:ext cx="4822651" cy="3565805"/>
            <a:chOff x="785958" y="178569"/>
            <a:chExt cx="7459743" cy="5515636"/>
          </a:xfrm>
        </p:grpSpPr>
        <p:grpSp>
          <p:nvGrpSpPr>
            <p:cNvPr id="2" name="グループ化 1"/>
            <p:cNvGrpSpPr>
              <a:grpSpLocks noChangeAspect="1"/>
            </p:cNvGrpSpPr>
            <p:nvPr/>
          </p:nvGrpSpPr>
          <p:grpSpPr>
            <a:xfrm>
              <a:off x="785958" y="178569"/>
              <a:ext cx="1800000" cy="1800000"/>
              <a:chOff x="1481010" y="657294"/>
              <a:chExt cx="1219200" cy="1219200"/>
            </a:xfrm>
          </p:grpSpPr>
          <p:pic>
            <p:nvPicPr>
              <p:cNvPr id="15" name="Picture 3" descr="C:\Users\Atsushi\Desktop\140130\NIH_31_20.jpg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1481010" y="657294"/>
                <a:ext cx="1219200" cy="1219200"/>
              </a:xfrm>
              <a:prstGeom prst="rect">
                <a:avLst/>
              </a:prstGeom>
              <a:noFill/>
            </p:spPr>
          </p:pic>
          <p:sp>
            <p:nvSpPr>
              <p:cNvPr id="17" name="テキスト ボックス 16"/>
              <p:cNvSpPr txBox="1"/>
              <p:nvPr/>
            </p:nvSpPr>
            <p:spPr>
              <a:xfrm>
                <a:off x="1481010" y="657294"/>
                <a:ext cx="690473" cy="3477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solidFill>
                      <a:schemeClr val="bg1"/>
                    </a:solidFill>
                  </a:rPr>
                  <a:t>CD31</a:t>
                </a:r>
                <a:r>
                  <a:rPr kumimoji="1" lang="en-US" altLang="ja-JP" sz="1400" baseline="30000" dirty="0">
                    <a:solidFill>
                      <a:schemeClr val="bg1"/>
                    </a:solidFill>
                  </a:rPr>
                  <a:t>-</a:t>
                </a:r>
                <a:endParaRPr kumimoji="1" lang="ja-JP" altLang="en-US" sz="1400" baseline="30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53" name="直線コネクタ 52"/>
              <p:cNvCxnSpPr/>
              <p:nvPr/>
            </p:nvCxnSpPr>
            <p:spPr>
              <a:xfrm>
                <a:off x="2254046" y="1738441"/>
                <a:ext cx="396000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" name="グループ化 2"/>
            <p:cNvGrpSpPr>
              <a:grpSpLocks noChangeAspect="1"/>
            </p:cNvGrpSpPr>
            <p:nvPr/>
          </p:nvGrpSpPr>
          <p:grpSpPr>
            <a:xfrm>
              <a:off x="2697171" y="178569"/>
              <a:ext cx="1800000" cy="1800000"/>
              <a:chOff x="2849162" y="657294"/>
              <a:chExt cx="1219200" cy="1219200"/>
            </a:xfrm>
          </p:grpSpPr>
          <p:pic>
            <p:nvPicPr>
              <p:cNvPr id="16" name="Picture 3" descr="C:\Users\Atsushi\Desktop\140130\NIH_105_20.jp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2849162" y="657294"/>
                <a:ext cx="1219200" cy="1219200"/>
              </a:xfrm>
              <a:prstGeom prst="rect">
                <a:avLst/>
              </a:prstGeom>
              <a:noFill/>
            </p:spPr>
          </p:pic>
          <p:sp>
            <p:nvSpPr>
              <p:cNvPr id="18" name="テキスト ボックス 17"/>
              <p:cNvSpPr txBox="1"/>
              <p:nvPr/>
            </p:nvSpPr>
            <p:spPr>
              <a:xfrm>
                <a:off x="2849162" y="657294"/>
                <a:ext cx="793718" cy="3477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solidFill>
                      <a:schemeClr val="bg1"/>
                    </a:solidFill>
                  </a:rPr>
                  <a:t>CD105</a:t>
                </a:r>
                <a:r>
                  <a:rPr kumimoji="1" lang="en-US" altLang="ja-JP" sz="1400" baseline="30000" dirty="0">
                    <a:solidFill>
                      <a:schemeClr val="bg1"/>
                    </a:solidFill>
                  </a:rPr>
                  <a:t>-</a:t>
                </a:r>
                <a:endParaRPr kumimoji="1" lang="ja-JP" altLang="en-US" sz="1400" baseline="30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55" name="直線コネクタ 54"/>
              <p:cNvCxnSpPr/>
              <p:nvPr/>
            </p:nvCxnSpPr>
            <p:spPr>
              <a:xfrm>
                <a:off x="3624342" y="1728915"/>
                <a:ext cx="396000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" name="グループ化 3"/>
            <p:cNvGrpSpPr>
              <a:grpSpLocks noChangeAspect="1"/>
            </p:cNvGrpSpPr>
            <p:nvPr/>
          </p:nvGrpSpPr>
          <p:grpSpPr>
            <a:xfrm>
              <a:off x="4571436" y="178569"/>
              <a:ext cx="1800000" cy="1800000"/>
              <a:chOff x="4217314" y="657294"/>
              <a:chExt cx="1219200" cy="1219200"/>
            </a:xfrm>
          </p:grpSpPr>
          <p:pic>
            <p:nvPicPr>
              <p:cNvPr id="19" name="Picture 6" descr="C:\Users\Atsushi\Desktop\140130\NIH_34_20_2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4217314" y="657294"/>
                <a:ext cx="1219200" cy="1219200"/>
              </a:xfrm>
              <a:prstGeom prst="rect">
                <a:avLst/>
              </a:prstGeom>
              <a:noFill/>
            </p:spPr>
          </p:pic>
          <p:sp>
            <p:nvSpPr>
              <p:cNvPr id="21" name="テキスト ボックス 20"/>
              <p:cNvSpPr txBox="1"/>
              <p:nvPr/>
            </p:nvSpPr>
            <p:spPr>
              <a:xfrm>
                <a:off x="4217314" y="668327"/>
                <a:ext cx="690473" cy="3477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solidFill>
                      <a:schemeClr val="bg1"/>
                    </a:solidFill>
                  </a:rPr>
                  <a:t>CD34</a:t>
                </a:r>
                <a:r>
                  <a:rPr kumimoji="1" lang="en-US" altLang="ja-JP" sz="1400" baseline="30000" dirty="0">
                    <a:solidFill>
                      <a:schemeClr val="bg1"/>
                    </a:solidFill>
                  </a:rPr>
                  <a:t>-</a:t>
                </a:r>
                <a:endParaRPr kumimoji="1" lang="ja-JP" altLang="en-US" sz="1400" baseline="30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56" name="直線コネクタ 55"/>
              <p:cNvCxnSpPr/>
              <p:nvPr/>
            </p:nvCxnSpPr>
            <p:spPr>
              <a:xfrm>
                <a:off x="5009402" y="1700337"/>
                <a:ext cx="396000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" name="グループ化 4"/>
            <p:cNvGrpSpPr>
              <a:grpSpLocks noChangeAspect="1"/>
            </p:cNvGrpSpPr>
            <p:nvPr/>
          </p:nvGrpSpPr>
          <p:grpSpPr>
            <a:xfrm>
              <a:off x="6445701" y="178569"/>
              <a:ext cx="1800000" cy="1800000"/>
              <a:chOff x="5585466" y="657294"/>
              <a:chExt cx="1219200" cy="1219200"/>
            </a:xfrm>
          </p:grpSpPr>
          <p:pic>
            <p:nvPicPr>
              <p:cNvPr id="20" name="Picture 7" descr="C:\Users\Atsushi\Desktop\140130\SMC_34_20_1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5585466" y="657294"/>
                <a:ext cx="1219200" cy="1219200"/>
              </a:xfrm>
              <a:prstGeom prst="rect">
                <a:avLst/>
              </a:prstGeom>
              <a:noFill/>
            </p:spPr>
          </p:pic>
          <p:sp>
            <p:nvSpPr>
              <p:cNvPr id="22" name="テキスト ボックス 21"/>
              <p:cNvSpPr txBox="1"/>
              <p:nvPr/>
            </p:nvSpPr>
            <p:spPr>
              <a:xfrm>
                <a:off x="5585466" y="668327"/>
                <a:ext cx="647002" cy="3477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solidFill>
                      <a:schemeClr val="bg1"/>
                    </a:solidFill>
                  </a:rPr>
                  <a:t>Flk-1</a:t>
                </a:r>
                <a:r>
                  <a:rPr kumimoji="1" lang="en-US" altLang="ja-JP" sz="1400" baseline="30000" dirty="0">
                    <a:solidFill>
                      <a:schemeClr val="bg1"/>
                    </a:solidFill>
                  </a:rPr>
                  <a:t>-</a:t>
                </a:r>
                <a:endParaRPr kumimoji="1" lang="ja-JP" altLang="en-US" sz="1400" baseline="30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57" name="直線コネクタ 56"/>
              <p:cNvCxnSpPr/>
              <p:nvPr/>
            </p:nvCxnSpPr>
            <p:spPr>
              <a:xfrm>
                <a:off x="6372791" y="1680722"/>
                <a:ext cx="396000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グループ化 23"/>
            <p:cNvGrpSpPr>
              <a:grpSpLocks noChangeAspect="1"/>
            </p:cNvGrpSpPr>
            <p:nvPr/>
          </p:nvGrpSpPr>
          <p:grpSpPr>
            <a:xfrm>
              <a:off x="785958" y="2036387"/>
              <a:ext cx="1800000" cy="1800000"/>
              <a:chOff x="1481010" y="1953438"/>
              <a:chExt cx="1219200" cy="1219200"/>
            </a:xfrm>
          </p:grpSpPr>
          <p:pic>
            <p:nvPicPr>
              <p:cNvPr id="6" name="Picture 2" descr="C:\Users\Atsushi\Desktop\140130\HUVEC_31_20.jpg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1481010" y="1953438"/>
                <a:ext cx="1219200" cy="1219200"/>
              </a:xfrm>
              <a:prstGeom prst="rect">
                <a:avLst/>
              </a:prstGeom>
              <a:noFill/>
            </p:spPr>
          </p:pic>
          <p:sp>
            <p:nvSpPr>
              <p:cNvPr id="8" name="テキスト ボックス 7"/>
              <p:cNvSpPr txBox="1"/>
              <p:nvPr/>
            </p:nvSpPr>
            <p:spPr>
              <a:xfrm>
                <a:off x="1481010" y="1953438"/>
                <a:ext cx="715832" cy="3477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solidFill>
                      <a:schemeClr val="bg1"/>
                    </a:solidFill>
                  </a:rPr>
                  <a:t>CD31</a:t>
                </a:r>
                <a:r>
                  <a:rPr kumimoji="1" lang="en-US" altLang="ja-JP" sz="1400" baseline="30000" dirty="0">
                    <a:solidFill>
                      <a:schemeClr val="bg1"/>
                    </a:solidFill>
                  </a:rPr>
                  <a:t>+</a:t>
                </a:r>
                <a:endParaRPr kumimoji="1" lang="ja-JP" altLang="en-US" sz="1400" baseline="30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58" name="直線コネクタ 57"/>
              <p:cNvCxnSpPr/>
              <p:nvPr/>
            </p:nvCxnSpPr>
            <p:spPr>
              <a:xfrm>
                <a:off x="2254048" y="3042522"/>
                <a:ext cx="396000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グループ化 28"/>
            <p:cNvGrpSpPr>
              <a:grpSpLocks noChangeAspect="1"/>
            </p:cNvGrpSpPr>
            <p:nvPr/>
          </p:nvGrpSpPr>
          <p:grpSpPr>
            <a:xfrm>
              <a:off x="2697171" y="2036387"/>
              <a:ext cx="1800000" cy="1800000"/>
              <a:chOff x="2849162" y="1953438"/>
              <a:chExt cx="1219200" cy="1219200"/>
            </a:xfrm>
          </p:grpSpPr>
          <p:pic>
            <p:nvPicPr>
              <p:cNvPr id="7" name="Picture 2" descr="C:\Users\Atsushi\Desktop\140130\HUVEC_105_20.jpg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2849162" y="1953438"/>
                <a:ext cx="1219200" cy="1219200"/>
              </a:xfrm>
              <a:prstGeom prst="rect">
                <a:avLst/>
              </a:prstGeom>
              <a:noFill/>
            </p:spPr>
          </p:pic>
          <p:sp>
            <p:nvSpPr>
              <p:cNvPr id="9" name="テキスト ボックス 8"/>
              <p:cNvSpPr txBox="1"/>
              <p:nvPr/>
            </p:nvSpPr>
            <p:spPr>
              <a:xfrm>
                <a:off x="2849162" y="1953438"/>
                <a:ext cx="819077" cy="3477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solidFill>
                      <a:schemeClr val="bg1"/>
                    </a:solidFill>
                  </a:rPr>
                  <a:t>CD105</a:t>
                </a:r>
                <a:r>
                  <a:rPr kumimoji="1" lang="en-US" altLang="ja-JP" sz="1400" baseline="30000" dirty="0">
                    <a:solidFill>
                      <a:schemeClr val="bg1"/>
                    </a:solidFill>
                  </a:rPr>
                  <a:t>+</a:t>
                </a:r>
                <a:endParaRPr kumimoji="1" lang="ja-JP" altLang="en-US" sz="1400" baseline="30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59" name="直線コネクタ 58"/>
              <p:cNvCxnSpPr/>
              <p:nvPr/>
            </p:nvCxnSpPr>
            <p:spPr>
              <a:xfrm>
                <a:off x="3630694" y="3020296"/>
                <a:ext cx="396000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グループ化 29"/>
            <p:cNvGrpSpPr>
              <a:grpSpLocks noChangeAspect="1"/>
            </p:cNvGrpSpPr>
            <p:nvPr/>
          </p:nvGrpSpPr>
          <p:grpSpPr>
            <a:xfrm>
              <a:off x="4571436" y="2036387"/>
              <a:ext cx="1800000" cy="1800000"/>
              <a:chOff x="4217314" y="1953438"/>
              <a:chExt cx="1219200" cy="1219200"/>
            </a:xfrm>
          </p:grpSpPr>
          <p:pic>
            <p:nvPicPr>
              <p:cNvPr id="11" name="Picture 5" descr="C:\Users\Atsushi\Desktop\140130\HUVEC_34_20_2.jpg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4217314" y="1953438"/>
                <a:ext cx="1219200" cy="1219200"/>
              </a:xfrm>
              <a:prstGeom prst="rect">
                <a:avLst/>
              </a:prstGeom>
              <a:noFill/>
            </p:spPr>
          </p:pic>
          <p:sp>
            <p:nvSpPr>
              <p:cNvPr id="12" name="テキスト ボックス 11"/>
              <p:cNvSpPr txBox="1"/>
              <p:nvPr/>
            </p:nvSpPr>
            <p:spPr>
              <a:xfrm>
                <a:off x="4217452" y="1953438"/>
                <a:ext cx="990645" cy="3477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solidFill>
                      <a:schemeClr val="bg1"/>
                    </a:solidFill>
                  </a:rPr>
                  <a:t>CD34</a:t>
                </a:r>
                <a:r>
                  <a:rPr kumimoji="1" lang="en-US" altLang="ja-JP" sz="1400" baseline="30000" dirty="0">
                    <a:solidFill>
                      <a:schemeClr val="bg1"/>
                    </a:solidFill>
                  </a:rPr>
                  <a:t>+/Low</a:t>
                </a:r>
                <a:endParaRPr kumimoji="1" lang="ja-JP" altLang="en-US" sz="1400" baseline="30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60" name="直線コネクタ 59"/>
              <p:cNvCxnSpPr/>
              <p:nvPr/>
            </p:nvCxnSpPr>
            <p:spPr>
              <a:xfrm>
                <a:off x="4967092" y="2991722"/>
                <a:ext cx="396000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グループ化 30"/>
            <p:cNvGrpSpPr>
              <a:grpSpLocks noChangeAspect="1"/>
            </p:cNvGrpSpPr>
            <p:nvPr/>
          </p:nvGrpSpPr>
          <p:grpSpPr>
            <a:xfrm>
              <a:off x="6445701" y="2036387"/>
              <a:ext cx="1800000" cy="1800000"/>
              <a:chOff x="5585466" y="1953438"/>
              <a:chExt cx="1219200" cy="1219200"/>
            </a:xfrm>
          </p:grpSpPr>
          <p:pic>
            <p:nvPicPr>
              <p:cNvPr id="10" name="Picture 5" descr="C:\Users\Atsushi\Desktop\140130\HUVEC_Flk_20_1.jpg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5585466" y="1953438"/>
                <a:ext cx="1219200" cy="1219200"/>
              </a:xfrm>
              <a:prstGeom prst="rect">
                <a:avLst/>
              </a:prstGeom>
              <a:noFill/>
            </p:spPr>
          </p:pic>
          <p:sp>
            <p:nvSpPr>
              <p:cNvPr id="13" name="テキスト ボックス 12"/>
              <p:cNvSpPr txBox="1"/>
              <p:nvPr/>
            </p:nvSpPr>
            <p:spPr>
              <a:xfrm>
                <a:off x="5585604" y="1953438"/>
                <a:ext cx="967097" cy="3477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solidFill>
                      <a:schemeClr val="bg1"/>
                    </a:solidFill>
                  </a:rPr>
                  <a:t>Flk-1</a:t>
                </a:r>
                <a:r>
                  <a:rPr lang="ja-JP" altLang="en-US" sz="1400" dirty="0">
                    <a:solidFill>
                      <a:schemeClr val="bg1"/>
                    </a:solidFill>
                  </a:rPr>
                  <a:t> </a:t>
                </a:r>
                <a:r>
                  <a:rPr lang="en-US" altLang="ja-JP" sz="1400" baseline="30000" dirty="0">
                    <a:solidFill>
                      <a:schemeClr val="bg1"/>
                    </a:solidFill>
                  </a:rPr>
                  <a:t>-/Low</a:t>
                </a:r>
                <a:endParaRPr kumimoji="1" lang="ja-JP" altLang="en-US" sz="1400" baseline="30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61" name="直線コネクタ 60"/>
              <p:cNvCxnSpPr/>
              <p:nvPr/>
            </p:nvCxnSpPr>
            <p:spPr>
              <a:xfrm>
                <a:off x="6364854" y="2991722"/>
                <a:ext cx="396000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" name="グループ化 39"/>
            <p:cNvGrpSpPr>
              <a:grpSpLocks noChangeAspect="1"/>
            </p:cNvGrpSpPr>
            <p:nvPr/>
          </p:nvGrpSpPr>
          <p:grpSpPr>
            <a:xfrm>
              <a:off x="6445701" y="3894205"/>
              <a:ext cx="1800000" cy="1800000"/>
              <a:chOff x="5607112" y="3325568"/>
              <a:chExt cx="1220400" cy="1220400"/>
            </a:xfrm>
          </p:grpSpPr>
          <p:pic>
            <p:nvPicPr>
              <p:cNvPr id="28" name="Picture 7" descr="C:\Users\Atsushi\Desktop\140130\#3_Flk_20_3.jpg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5607112" y="3325568"/>
                <a:ext cx="1220400" cy="1220400"/>
              </a:xfrm>
              <a:prstGeom prst="rect">
                <a:avLst/>
              </a:prstGeom>
              <a:noFill/>
            </p:spPr>
          </p:pic>
          <p:sp>
            <p:nvSpPr>
              <p:cNvPr id="37" name="テキスト ボックス 36"/>
              <p:cNvSpPr txBox="1"/>
              <p:nvPr/>
            </p:nvSpPr>
            <p:spPr>
              <a:xfrm>
                <a:off x="5607112" y="3336602"/>
                <a:ext cx="673022" cy="3481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solidFill>
                      <a:schemeClr val="bg1"/>
                    </a:solidFill>
                  </a:rPr>
                  <a:t>Flk-1</a:t>
                </a:r>
                <a:r>
                  <a:rPr kumimoji="1" lang="en-US" altLang="ja-JP" sz="1400" baseline="30000" dirty="0">
                    <a:solidFill>
                      <a:schemeClr val="bg1"/>
                    </a:solidFill>
                  </a:rPr>
                  <a:t>+</a:t>
                </a:r>
                <a:endParaRPr kumimoji="1" lang="ja-JP" altLang="en-US" sz="1400" baseline="30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66" name="直線コネクタ 65"/>
              <p:cNvCxnSpPr/>
              <p:nvPr/>
            </p:nvCxnSpPr>
            <p:spPr>
              <a:xfrm>
                <a:off x="6390692" y="4363852"/>
                <a:ext cx="396000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" name="グループ化 38"/>
            <p:cNvGrpSpPr>
              <a:grpSpLocks noChangeAspect="1"/>
            </p:cNvGrpSpPr>
            <p:nvPr/>
          </p:nvGrpSpPr>
          <p:grpSpPr>
            <a:xfrm>
              <a:off x="4571436" y="3894205"/>
              <a:ext cx="1800000" cy="1800000"/>
              <a:chOff x="4238960" y="3325568"/>
              <a:chExt cx="1220400" cy="1220400"/>
            </a:xfrm>
          </p:grpSpPr>
          <p:pic>
            <p:nvPicPr>
              <p:cNvPr id="27" name="Picture 4" descr="C:\Users\Atsushi\Desktop\140130\#3_34_20_1.jpg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4238960" y="3325568"/>
                <a:ext cx="1220400" cy="1220400"/>
              </a:xfrm>
              <a:prstGeom prst="rect">
                <a:avLst/>
              </a:prstGeom>
              <a:noFill/>
            </p:spPr>
          </p:pic>
          <p:sp>
            <p:nvSpPr>
              <p:cNvPr id="36" name="テキスト ボックス 35"/>
              <p:cNvSpPr txBox="1"/>
              <p:nvPr/>
            </p:nvSpPr>
            <p:spPr>
              <a:xfrm>
                <a:off x="4238960" y="3336602"/>
                <a:ext cx="716536" cy="3481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solidFill>
                      <a:schemeClr val="bg1"/>
                    </a:solidFill>
                  </a:rPr>
                  <a:t>CD34</a:t>
                </a:r>
                <a:r>
                  <a:rPr kumimoji="1" lang="en-US" altLang="ja-JP" sz="1400" baseline="30000" dirty="0">
                    <a:solidFill>
                      <a:schemeClr val="bg1"/>
                    </a:solidFill>
                  </a:rPr>
                  <a:t>+</a:t>
                </a:r>
                <a:endParaRPr kumimoji="1" lang="ja-JP" altLang="en-US" sz="1400" baseline="30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67" name="直線コネクタ 66"/>
              <p:cNvCxnSpPr/>
              <p:nvPr/>
            </p:nvCxnSpPr>
            <p:spPr>
              <a:xfrm>
                <a:off x="4990790" y="4342644"/>
                <a:ext cx="396000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グループ化 37"/>
            <p:cNvGrpSpPr>
              <a:grpSpLocks noChangeAspect="1"/>
            </p:cNvGrpSpPr>
            <p:nvPr/>
          </p:nvGrpSpPr>
          <p:grpSpPr>
            <a:xfrm>
              <a:off x="2697171" y="3894205"/>
              <a:ext cx="1800000" cy="1800000"/>
              <a:chOff x="2870808" y="3325568"/>
              <a:chExt cx="1220400" cy="1220400"/>
            </a:xfrm>
          </p:grpSpPr>
          <p:pic>
            <p:nvPicPr>
              <p:cNvPr id="26" name="Picture 8" descr="C:\Users\Atsushi\Desktop\140130\#3_105_20_3.jpg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2870808" y="3325568"/>
                <a:ext cx="1220400" cy="1220400"/>
              </a:xfrm>
              <a:prstGeom prst="rect">
                <a:avLst/>
              </a:prstGeom>
              <a:noFill/>
            </p:spPr>
          </p:pic>
          <p:sp>
            <p:nvSpPr>
              <p:cNvPr id="35" name="テキスト ボックス 34"/>
              <p:cNvSpPr txBox="1"/>
              <p:nvPr/>
            </p:nvSpPr>
            <p:spPr>
              <a:xfrm>
                <a:off x="2870808" y="3325568"/>
                <a:ext cx="819883" cy="3481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solidFill>
                      <a:schemeClr val="bg1"/>
                    </a:solidFill>
                  </a:rPr>
                  <a:t>CD105</a:t>
                </a:r>
                <a:r>
                  <a:rPr kumimoji="1" lang="en-US" altLang="ja-JP" sz="1400" baseline="30000" dirty="0">
                    <a:solidFill>
                      <a:schemeClr val="bg1"/>
                    </a:solidFill>
                  </a:rPr>
                  <a:t>+</a:t>
                </a:r>
                <a:endParaRPr kumimoji="1" lang="ja-JP" altLang="en-US" sz="1400" baseline="30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68" name="直線コネクタ 67"/>
              <p:cNvCxnSpPr/>
              <p:nvPr/>
            </p:nvCxnSpPr>
            <p:spPr>
              <a:xfrm>
                <a:off x="3643846" y="4401952"/>
                <a:ext cx="396000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グループ化 31"/>
            <p:cNvGrpSpPr>
              <a:grpSpLocks noChangeAspect="1"/>
            </p:cNvGrpSpPr>
            <p:nvPr/>
          </p:nvGrpSpPr>
          <p:grpSpPr>
            <a:xfrm>
              <a:off x="785958" y="3894205"/>
              <a:ext cx="1800000" cy="1800000"/>
              <a:chOff x="1502656" y="3325568"/>
              <a:chExt cx="1220400" cy="1220400"/>
            </a:xfrm>
          </p:grpSpPr>
          <p:pic>
            <p:nvPicPr>
              <p:cNvPr id="25" name="Picture 5" descr="C:\Users\Atsushi\Desktop\140130\#3_31_20_3.jpg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1502656" y="3325568"/>
                <a:ext cx="1220400" cy="1220400"/>
              </a:xfrm>
              <a:prstGeom prst="rect">
                <a:avLst/>
              </a:prstGeom>
              <a:noFill/>
            </p:spPr>
          </p:pic>
          <p:sp>
            <p:nvSpPr>
              <p:cNvPr id="34" name="テキスト ボックス 33"/>
              <p:cNvSpPr txBox="1"/>
              <p:nvPr/>
            </p:nvSpPr>
            <p:spPr>
              <a:xfrm>
                <a:off x="1502656" y="3325568"/>
                <a:ext cx="716536" cy="3481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solidFill>
                      <a:schemeClr val="bg1"/>
                    </a:solidFill>
                  </a:rPr>
                  <a:t>CD31</a:t>
                </a:r>
                <a:r>
                  <a:rPr kumimoji="1" lang="en-US" altLang="ja-JP" sz="1400" baseline="30000" dirty="0">
                    <a:solidFill>
                      <a:schemeClr val="bg1"/>
                    </a:solidFill>
                  </a:rPr>
                  <a:t>+</a:t>
                </a:r>
                <a:endParaRPr kumimoji="1" lang="ja-JP" altLang="en-US" sz="1400" baseline="30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69" name="直線コネクタ 68"/>
              <p:cNvCxnSpPr/>
              <p:nvPr/>
            </p:nvCxnSpPr>
            <p:spPr>
              <a:xfrm>
                <a:off x="2282044" y="4433702"/>
                <a:ext cx="396000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71" name="テキスト ボックス 70"/>
          <p:cNvSpPr txBox="1"/>
          <p:nvPr/>
        </p:nvSpPr>
        <p:spPr>
          <a:xfrm>
            <a:off x="639011" y="4993268"/>
            <a:ext cx="76194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/>
              <a:t>Supplementally Figure S3</a:t>
            </a:r>
            <a:r>
              <a:rPr kumimoji="1" lang="en-US" altLang="ja-JP" sz="1200" dirty="0"/>
              <a:t> </a:t>
            </a:r>
            <a:r>
              <a:rPr kumimoji="1" lang="en-US" altLang="ja-JP" sz="1200" b="1" dirty="0"/>
              <a:t>Surface marker analysis of CC-3D</a:t>
            </a:r>
            <a:r>
              <a:rPr kumimoji="1" lang="en-US" altLang="ja-JP" sz="1200" b="1" baseline="-25000" dirty="0"/>
              <a:t>1</a:t>
            </a:r>
            <a:r>
              <a:rPr kumimoji="1" lang="en-US" altLang="ja-JP" sz="1200" b="1" dirty="0"/>
              <a:t> and CC-3D</a:t>
            </a:r>
            <a:r>
              <a:rPr kumimoji="1" lang="en-US" altLang="ja-JP" sz="1200" b="1" baseline="-25000" dirty="0"/>
              <a:t>2</a:t>
            </a:r>
            <a:r>
              <a:rPr kumimoji="1" lang="en-US" altLang="ja-JP" sz="1200" b="1" dirty="0"/>
              <a:t>. </a:t>
            </a:r>
            <a:r>
              <a:rPr lang="en-US" altLang="ja-JP" sz="1200" dirty="0"/>
              <a:t>Fluorescence and transmission cell images of fibroblast cell (FCs), endothelial cell (</a:t>
            </a:r>
            <a:r>
              <a:rPr lang="en-US" altLang="ja-JP" sz="1200" dirty="0" err="1"/>
              <a:t>Ecs</a:t>
            </a:r>
            <a:r>
              <a:rPr lang="en-US" altLang="ja-JP" sz="1200" dirty="0"/>
              <a:t>), CC-3D</a:t>
            </a:r>
            <a:r>
              <a:rPr lang="en-US" altLang="ja-JP" sz="1200" baseline="-25000" dirty="0"/>
              <a:t>1</a:t>
            </a:r>
            <a:r>
              <a:rPr lang="en-US" altLang="ja-JP" sz="1200" dirty="0"/>
              <a:t>, and CC-3D</a:t>
            </a:r>
            <a:r>
              <a:rPr lang="en-US" altLang="ja-JP" sz="1200" baseline="-25000" dirty="0"/>
              <a:t>2</a:t>
            </a:r>
            <a:r>
              <a:rPr lang="en-US" altLang="ja-JP" sz="1200" dirty="0"/>
              <a:t>. The cells were stained with rhodamine-conjugated anti-CD31, anti-CD105, anti-CD34, and anti-Flk-1 antibody. Scale bar indicates 200 </a:t>
            </a:r>
            <a:r>
              <a:rPr lang="en-US" altLang="ja-JP" sz="1200" dirty="0" err="1"/>
              <a:t>μm</a:t>
            </a:r>
            <a:r>
              <a:rPr lang="en-US" altLang="ja-JP" sz="1200" dirty="0"/>
              <a:t>. </a:t>
            </a:r>
            <a:endParaRPr kumimoji="1" lang="en-US" altLang="ja-JP" sz="1200" dirty="0"/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984DCAB5-3C99-4C00-80CB-9B4DB73B68C5}"/>
              </a:ext>
            </a:extLst>
          </p:cNvPr>
          <p:cNvCxnSpPr/>
          <p:nvPr/>
        </p:nvCxnSpPr>
        <p:spPr>
          <a:xfrm>
            <a:off x="1425019" y="2333204"/>
            <a:ext cx="595375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8B243957-E5B6-4663-A63C-1FFE9B691DDA}"/>
              </a:ext>
            </a:extLst>
          </p:cNvPr>
          <p:cNvCxnSpPr/>
          <p:nvPr/>
        </p:nvCxnSpPr>
        <p:spPr>
          <a:xfrm>
            <a:off x="1425019" y="3536384"/>
            <a:ext cx="595375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B65D5C46-F479-43B5-A4CF-06646484FD2C}"/>
              </a:ext>
            </a:extLst>
          </p:cNvPr>
          <p:cNvSpPr txBox="1"/>
          <p:nvPr/>
        </p:nvSpPr>
        <p:spPr>
          <a:xfrm rot="16200000">
            <a:off x="1656784" y="1580741"/>
            <a:ext cx="396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FCs</a:t>
            </a:r>
            <a:endParaRPr kumimoji="1" lang="ja-JP" altLang="en-US" sz="1200" dirty="0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BB751D0F-4AF9-4E75-B5FD-1522CD67B724}"/>
              </a:ext>
            </a:extLst>
          </p:cNvPr>
          <p:cNvSpPr txBox="1"/>
          <p:nvPr/>
        </p:nvSpPr>
        <p:spPr>
          <a:xfrm rot="16200000">
            <a:off x="1654606" y="2786229"/>
            <a:ext cx="4008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ECs</a:t>
            </a:r>
            <a:endParaRPr kumimoji="1" lang="ja-JP" altLang="en-US" sz="1200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2DB629E7-8587-49B5-B0D3-1E68800C21B2}"/>
              </a:ext>
            </a:extLst>
          </p:cNvPr>
          <p:cNvSpPr txBox="1"/>
          <p:nvPr/>
        </p:nvSpPr>
        <p:spPr>
          <a:xfrm rot="16200000">
            <a:off x="1254562" y="4062230"/>
            <a:ext cx="1200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CC-3D</a:t>
            </a:r>
            <a:r>
              <a:rPr lang="en-US" altLang="ja-JP" sz="1200" baseline="-25000" dirty="0"/>
              <a:t>1</a:t>
            </a:r>
            <a:r>
              <a:rPr lang="en-US" altLang="ja-JP" sz="1200" dirty="0"/>
              <a:t> + CC-3D</a:t>
            </a:r>
            <a:r>
              <a:rPr lang="en-US" altLang="ja-JP" sz="1200" baseline="-25000" dirty="0"/>
              <a:t>2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9813517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CF08EAE1-711A-8240-4D3A-C99A21C7B8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1733786"/>
              </p:ext>
            </p:extLst>
          </p:nvPr>
        </p:nvGraphicFramePr>
        <p:xfrm>
          <a:off x="2289100" y="0"/>
          <a:ext cx="5475287" cy="5086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474783" imgH="5086095" progId="Prism9.Document">
                  <p:embed/>
                </p:oleObj>
              </mc:Choice>
              <mc:Fallback>
                <p:oleObj name="Prism 9" r:id="rId2" imgW="5474783" imgH="508609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89100" y="0"/>
                        <a:ext cx="5475287" cy="5086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C48F304-1D2F-787B-F285-2548F1EC2060}"/>
              </a:ext>
            </a:extLst>
          </p:cNvPr>
          <p:cNvSpPr txBox="1"/>
          <p:nvPr/>
        </p:nvSpPr>
        <p:spPr>
          <a:xfrm>
            <a:off x="666100" y="5286009"/>
            <a:ext cx="71472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/>
              <a:t>Supplementally Figure S4 RNA sequencing analysis. </a:t>
            </a:r>
            <a:r>
              <a:rPr kumimoji="1" lang="en-US" altLang="ja-JP" sz="1200" dirty="0"/>
              <a:t>Heat map representation of macrophage-related genes in </a:t>
            </a:r>
            <a:r>
              <a:rPr kumimoji="1" lang="en-US" altLang="ja-JP" sz="1200" dirty="0" err="1"/>
              <a:t>MoP</a:t>
            </a:r>
            <a:r>
              <a:rPr kumimoji="1" lang="en-US" altLang="ja-JP" sz="1200" dirty="0"/>
              <a:t>, </a:t>
            </a:r>
            <a:r>
              <a:rPr kumimoji="1" lang="en-US" altLang="ja-JP" sz="1200" dirty="0" err="1"/>
              <a:t>MoN</a:t>
            </a:r>
            <a:r>
              <a:rPr kumimoji="1" lang="en-US" altLang="ja-JP" sz="1200" dirty="0"/>
              <a:t>, CC-3H, CC-3D1, and CC-3D2. Comparison of specific genes known to be expressed in monocyte and macrophage (MΦ) including M1 and M2 phase. </a:t>
            </a:r>
            <a:endParaRPr kumimoji="1" lang="en-US" altLang="ja-JP" sz="1200" dirty="0">
              <a:highlight>
                <a:srgbClr val="FFFF00"/>
              </a:highlight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EDDA7CC-C976-EA93-5C1C-9EC2D1B16AEE}"/>
              </a:ext>
            </a:extLst>
          </p:cNvPr>
          <p:cNvSpPr txBox="1"/>
          <p:nvPr/>
        </p:nvSpPr>
        <p:spPr>
          <a:xfrm rot="16200000">
            <a:off x="555689" y="1289862"/>
            <a:ext cx="2406611" cy="338554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Mo</a:t>
            </a:r>
            <a:endParaRPr kumimoji="1" lang="ja-JP" altLang="en-US" sz="16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6B2E3E0-D8DD-FE80-EFAF-962FB405AA43}"/>
              </a:ext>
            </a:extLst>
          </p:cNvPr>
          <p:cNvSpPr txBox="1"/>
          <p:nvPr/>
        </p:nvSpPr>
        <p:spPr>
          <a:xfrm rot="16200000">
            <a:off x="1722803" y="3309291"/>
            <a:ext cx="697498" cy="338554"/>
          </a:xfrm>
          <a:prstGeom prst="rect">
            <a:avLst/>
          </a:prstGeom>
          <a:solidFill>
            <a:srgbClr val="FF0000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M1</a:t>
            </a:r>
            <a:endParaRPr kumimoji="1" lang="ja-JP" altLang="en-US" sz="16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4E4902B-5510-1CFF-73E9-BC35CDD4A623}"/>
              </a:ext>
            </a:extLst>
          </p:cNvPr>
          <p:cNvSpPr txBox="1"/>
          <p:nvPr/>
        </p:nvSpPr>
        <p:spPr>
          <a:xfrm rot="16200000">
            <a:off x="1621477" y="4108117"/>
            <a:ext cx="900152" cy="338554"/>
          </a:xfrm>
          <a:prstGeom prst="rect">
            <a:avLst/>
          </a:prstGeom>
          <a:solidFill>
            <a:srgbClr val="00B0F0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M2</a:t>
            </a:r>
            <a:endParaRPr kumimoji="1" lang="ja-JP" altLang="en-US" sz="16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2A185FE-4F19-6BBB-4757-C293020FDC1F}"/>
              </a:ext>
            </a:extLst>
          </p:cNvPr>
          <p:cNvSpPr txBox="1"/>
          <p:nvPr/>
        </p:nvSpPr>
        <p:spPr>
          <a:xfrm rot="16200000">
            <a:off x="731450" y="3530649"/>
            <a:ext cx="2055088" cy="338554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MΦ</a:t>
            </a:r>
            <a:endParaRPr kumimoji="1" lang="ja-JP" altLang="en-US" sz="1600" dirty="0"/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B4768E1F-8AE2-B542-7722-AA379DEBF87D}"/>
              </a:ext>
            </a:extLst>
          </p:cNvPr>
          <p:cNvCxnSpPr/>
          <p:nvPr/>
        </p:nvCxnSpPr>
        <p:spPr>
          <a:xfrm>
            <a:off x="1604830" y="2652504"/>
            <a:ext cx="2056771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B7F7F2CD-82B8-4636-56B2-D69CA7165F46}"/>
              </a:ext>
            </a:extLst>
          </p:cNvPr>
          <p:cNvCxnSpPr/>
          <p:nvPr/>
        </p:nvCxnSpPr>
        <p:spPr>
          <a:xfrm>
            <a:off x="1604830" y="4727470"/>
            <a:ext cx="2056771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7D26C11D-1F1B-2BB5-BF7A-76F4F9521F9F}"/>
              </a:ext>
            </a:extLst>
          </p:cNvPr>
          <p:cNvCxnSpPr/>
          <p:nvPr/>
        </p:nvCxnSpPr>
        <p:spPr>
          <a:xfrm>
            <a:off x="1604830" y="245894"/>
            <a:ext cx="2056771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6CD18868-82F4-19F9-281A-54F63332AD0F}"/>
              </a:ext>
            </a:extLst>
          </p:cNvPr>
          <p:cNvCxnSpPr>
            <a:cxnSpLocks/>
          </p:cNvCxnSpPr>
          <p:nvPr/>
        </p:nvCxnSpPr>
        <p:spPr>
          <a:xfrm>
            <a:off x="1914452" y="3129820"/>
            <a:ext cx="1747149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B695E59D-EA2C-AAAA-1788-0AB3EC2F46C1}"/>
              </a:ext>
            </a:extLst>
          </p:cNvPr>
          <p:cNvCxnSpPr>
            <a:cxnSpLocks/>
          </p:cNvCxnSpPr>
          <p:nvPr/>
        </p:nvCxnSpPr>
        <p:spPr>
          <a:xfrm>
            <a:off x="1914975" y="3827318"/>
            <a:ext cx="1747149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7F8B5D4-6B9F-551D-15BD-D673609E03AA}"/>
              </a:ext>
            </a:extLst>
          </p:cNvPr>
          <p:cNvSpPr txBox="1"/>
          <p:nvPr/>
        </p:nvSpPr>
        <p:spPr>
          <a:xfrm>
            <a:off x="3711070" y="4777075"/>
            <a:ext cx="48442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b="1" dirty="0" err="1"/>
              <a:t>MoP</a:t>
            </a:r>
            <a:endParaRPr kumimoji="1" lang="ja-JP" altLang="en-US" sz="1200" b="1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B93BCFE-0A43-5249-CA98-93B62D0D0420}"/>
              </a:ext>
            </a:extLst>
          </p:cNvPr>
          <p:cNvSpPr txBox="1"/>
          <p:nvPr/>
        </p:nvSpPr>
        <p:spPr>
          <a:xfrm>
            <a:off x="4323674" y="4777075"/>
            <a:ext cx="50366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b="1" dirty="0" err="1"/>
              <a:t>MoN</a:t>
            </a:r>
            <a:endParaRPr kumimoji="1" lang="ja-JP" altLang="en-US" sz="1200" b="1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1924A10-C1BC-F172-2174-1CAC7452F563}"/>
              </a:ext>
            </a:extLst>
          </p:cNvPr>
          <p:cNvSpPr txBox="1"/>
          <p:nvPr/>
        </p:nvSpPr>
        <p:spPr>
          <a:xfrm>
            <a:off x="4935804" y="4777075"/>
            <a:ext cx="5709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CC-3H</a:t>
            </a:r>
            <a:endParaRPr kumimoji="1" lang="ja-JP" altLang="en-US" sz="1200" b="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D163A56-AAD7-4344-7702-C371361015D0}"/>
              </a:ext>
            </a:extLst>
          </p:cNvPr>
          <p:cNvSpPr txBox="1"/>
          <p:nvPr/>
        </p:nvSpPr>
        <p:spPr>
          <a:xfrm>
            <a:off x="5542058" y="4777075"/>
            <a:ext cx="62228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CC-3D</a:t>
            </a:r>
            <a:r>
              <a:rPr kumimoji="1" lang="en-US" altLang="ja-JP" sz="1200" b="1" baseline="-25000" dirty="0"/>
              <a:t>1</a:t>
            </a:r>
            <a:endParaRPr kumimoji="1" lang="ja-JP" altLang="en-US" sz="1200" b="1" baseline="-250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7DEFE8A-F98F-C663-A191-BE26406B9FA2}"/>
              </a:ext>
            </a:extLst>
          </p:cNvPr>
          <p:cNvSpPr txBox="1"/>
          <p:nvPr/>
        </p:nvSpPr>
        <p:spPr>
          <a:xfrm>
            <a:off x="6182898" y="4777075"/>
            <a:ext cx="62228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CC-3D</a:t>
            </a:r>
            <a:r>
              <a:rPr kumimoji="1" lang="en-US" altLang="ja-JP" sz="1200" b="1" baseline="-25000" dirty="0"/>
              <a:t>2</a:t>
            </a:r>
            <a:endParaRPr kumimoji="1" lang="ja-JP" altLang="en-US" sz="1200" b="1" baseline="-25000" dirty="0"/>
          </a:p>
        </p:txBody>
      </p:sp>
    </p:spTree>
    <p:extLst>
      <p:ext uri="{BB962C8B-B14F-4D97-AF65-F5344CB8AC3E}">
        <p14:creationId xmlns:p14="http://schemas.microsoft.com/office/powerpoint/2010/main" val="1911471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敷物 が含まれている画像&#10;&#10;自動的に生成された説明">
            <a:extLst>
              <a:ext uri="{FF2B5EF4-FFF2-40B4-BE49-F238E27FC236}">
                <a16:creationId xmlns:a16="http://schemas.microsoft.com/office/drawing/2014/main" id="{FB3AB3F2-726E-C0E8-9EBF-151BFB1526B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440" t="10231" r="22658" b="9581"/>
          <a:stretch/>
        </p:blipFill>
        <p:spPr>
          <a:xfrm>
            <a:off x="666101" y="1235328"/>
            <a:ext cx="2536843" cy="17957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図 4" descr="敷物 が含まれている画像&#10;&#10;自動的に生成された説明">
            <a:extLst>
              <a:ext uri="{FF2B5EF4-FFF2-40B4-BE49-F238E27FC236}">
                <a16:creationId xmlns:a16="http://schemas.microsoft.com/office/drawing/2014/main" id="{39EB7D14-3FF7-FA91-2F2E-500133C4E8F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441" t="16686" r="20438"/>
          <a:stretch/>
        </p:blipFill>
        <p:spPr>
          <a:xfrm>
            <a:off x="666100" y="3239967"/>
            <a:ext cx="2536843" cy="17957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図 5" descr="背景パターン&#10;&#10;自動的に生成された説明">
            <a:extLst>
              <a:ext uri="{FF2B5EF4-FFF2-40B4-BE49-F238E27FC236}">
                <a16:creationId xmlns:a16="http://schemas.microsoft.com/office/drawing/2014/main" id="{1496A5AB-D5E6-7A9B-0691-536E5DBC402D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440" t="8343" r="20439" b="8343"/>
          <a:stretch/>
        </p:blipFill>
        <p:spPr>
          <a:xfrm>
            <a:off x="3367175" y="1235328"/>
            <a:ext cx="2536844" cy="17957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図 6" descr="屋外, 砂浜, 水, 砂 が含まれている画像&#10;&#10;自動的に生成された説明">
            <a:extLst>
              <a:ext uri="{FF2B5EF4-FFF2-40B4-BE49-F238E27FC236}">
                <a16:creationId xmlns:a16="http://schemas.microsoft.com/office/drawing/2014/main" id="{9D9E10F4-43C0-1894-223A-067DC956FC0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440" t="16686" r="20439"/>
          <a:stretch/>
        </p:blipFill>
        <p:spPr>
          <a:xfrm>
            <a:off x="3404215" y="3236134"/>
            <a:ext cx="2536844" cy="17957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図 7" descr="砂浜に並んでいる&#10;&#10;低い精度で自動的に生成された説明">
            <a:extLst>
              <a:ext uri="{FF2B5EF4-FFF2-40B4-BE49-F238E27FC236}">
                <a16:creationId xmlns:a16="http://schemas.microsoft.com/office/drawing/2014/main" id="{EEACE29C-F6A7-67E6-D33F-3328968A6C3B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440" t="16686" r="20439"/>
          <a:stretch/>
        </p:blipFill>
        <p:spPr>
          <a:xfrm>
            <a:off x="6093257" y="1235328"/>
            <a:ext cx="2536843" cy="17957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1B0F619-A575-AE20-D137-4F1745B4C702}"/>
              </a:ext>
            </a:extLst>
          </p:cNvPr>
          <p:cNvSpPr txBox="1"/>
          <p:nvPr/>
        </p:nvSpPr>
        <p:spPr>
          <a:xfrm>
            <a:off x="666100" y="5286009"/>
            <a:ext cx="796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/>
              <a:t>Supplementally Figure S5 Vascular tissue reconstruction </a:t>
            </a:r>
            <a:r>
              <a:rPr lang="en-US" altLang="ja-JP" sz="1200" b="1" dirty="0"/>
              <a:t>by of the decellularized vascular graft 12 months after transplantation</a:t>
            </a:r>
            <a:r>
              <a:rPr lang="ja-JP" altLang="en-US" sz="1200" b="1" dirty="0"/>
              <a:t> </a:t>
            </a:r>
            <a:r>
              <a:rPr lang="en-US" altLang="ja-JP" sz="1200" b="1" dirty="0"/>
              <a:t>for</a:t>
            </a:r>
            <a:r>
              <a:rPr lang="ja-JP" altLang="en-US" sz="1200" b="1" dirty="0"/>
              <a:t> </a:t>
            </a:r>
            <a:r>
              <a:rPr lang="en-US" altLang="ja-JP" sz="1200" b="1" dirty="0"/>
              <a:t>goat median artery replacement model.  a-c</a:t>
            </a:r>
            <a:r>
              <a:rPr lang="en-US" altLang="ja-JP" sz="1200" dirty="0"/>
              <a:t>, The longitudinal cross-section of the transplanted graft was evaluated by (</a:t>
            </a:r>
            <a:r>
              <a:rPr lang="en-US" altLang="ja-JP" sz="1200" b="1" dirty="0"/>
              <a:t>a</a:t>
            </a:r>
            <a:r>
              <a:rPr lang="en-US" altLang="ja-JP" sz="1200" dirty="0"/>
              <a:t>) HE, (</a:t>
            </a:r>
            <a:r>
              <a:rPr lang="en-US" altLang="ja-JP" sz="1200" b="1" dirty="0"/>
              <a:t>b</a:t>
            </a:r>
            <a:r>
              <a:rPr lang="en-US" altLang="ja-JP" sz="1200" dirty="0"/>
              <a:t>) EVG, and (</a:t>
            </a:r>
            <a:r>
              <a:rPr lang="en-US" altLang="ja-JP" sz="1200" b="1" dirty="0"/>
              <a:t>c</a:t>
            </a:r>
            <a:r>
              <a:rPr lang="en-US" altLang="ja-JP" sz="1200" dirty="0"/>
              <a:t>) von </a:t>
            </a:r>
            <a:r>
              <a:rPr lang="en-US" altLang="ja-JP" sz="1200" dirty="0" err="1"/>
              <a:t>Kossa</a:t>
            </a:r>
            <a:r>
              <a:rPr lang="en-US" altLang="ja-JP" sz="1200" dirty="0"/>
              <a:t> to investigate the matrix structure. </a:t>
            </a:r>
            <a:r>
              <a:rPr lang="en-US" altLang="ja-JP" sz="1200" b="1" dirty="0" err="1"/>
              <a:t>d,e</a:t>
            </a:r>
            <a:r>
              <a:rPr lang="en-US" altLang="ja-JP" sz="1200" dirty="0"/>
              <a:t>, Medium and intima layers were evaluated by </a:t>
            </a:r>
            <a:r>
              <a:rPr lang="en-US" altLang="ja-JP" sz="1200" b="1" dirty="0"/>
              <a:t>(d) </a:t>
            </a:r>
            <a:r>
              <a:rPr lang="en-US" altLang="ja-JP" sz="1200" dirty="0"/>
              <a:t>anti-αSMA and </a:t>
            </a:r>
            <a:r>
              <a:rPr lang="en-US" altLang="ja-JP" sz="1200" b="1" dirty="0"/>
              <a:t>(e) </a:t>
            </a:r>
            <a:r>
              <a:rPr lang="en-US" altLang="ja-JP" sz="1200" dirty="0"/>
              <a:t>anti-</a:t>
            </a:r>
            <a:r>
              <a:rPr lang="en-US" altLang="ja-JP" sz="1200" dirty="0" err="1"/>
              <a:t>vWF</a:t>
            </a:r>
            <a:r>
              <a:rPr lang="en-US" altLang="ja-JP" sz="1200" dirty="0"/>
              <a:t> antibodies staining. Scale bars indicate 200 </a:t>
            </a:r>
            <a:r>
              <a:rPr lang="en-US" altLang="ja-JP" sz="1200" dirty="0" err="1"/>
              <a:t>μm</a:t>
            </a:r>
            <a:r>
              <a:rPr lang="en-US" altLang="ja-JP" sz="1200" dirty="0"/>
              <a:t>. </a:t>
            </a:r>
            <a:endParaRPr kumimoji="1" lang="en-US" altLang="ja-JP" sz="12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CE59328-5582-C12A-68FB-6B6C1C70AC51}"/>
              </a:ext>
            </a:extLst>
          </p:cNvPr>
          <p:cNvSpPr txBox="1"/>
          <p:nvPr/>
        </p:nvSpPr>
        <p:spPr>
          <a:xfrm>
            <a:off x="666100" y="1235328"/>
            <a:ext cx="440674" cy="369332"/>
          </a:xfrm>
          <a:prstGeom prst="rect">
            <a:avLst/>
          </a:prstGeom>
          <a:solidFill>
            <a:schemeClr val="bg1">
              <a:alpha val="5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a)</a:t>
            </a:r>
            <a:endParaRPr kumimoji="1" lang="ja-JP" altLang="en-US" dirty="0"/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F92FFBDE-8A5D-4463-673A-01BDDBF8DF48}"/>
              </a:ext>
            </a:extLst>
          </p:cNvPr>
          <p:cNvCxnSpPr>
            <a:cxnSpLocks/>
          </p:cNvCxnSpPr>
          <p:nvPr/>
        </p:nvCxnSpPr>
        <p:spPr>
          <a:xfrm>
            <a:off x="2414588" y="2786063"/>
            <a:ext cx="5715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E3DA26F2-6778-658B-DA09-C950B0F3AF68}"/>
              </a:ext>
            </a:extLst>
          </p:cNvPr>
          <p:cNvCxnSpPr>
            <a:cxnSpLocks/>
          </p:cNvCxnSpPr>
          <p:nvPr/>
        </p:nvCxnSpPr>
        <p:spPr>
          <a:xfrm>
            <a:off x="2414588" y="4795838"/>
            <a:ext cx="5715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C07E1B46-1B52-E82E-CE2A-46F9A9B27DD7}"/>
              </a:ext>
            </a:extLst>
          </p:cNvPr>
          <p:cNvCxnSpPr>
            <a:cxnSpLocks/>
          </p:cNvCxnSpPr>
          <p:nvPr/>
        </p:nvCxnSpPr>
        <p:spPr>
          <a:xfrm>
            <a:off x="5205407" y="4772582"/>
            <a:ext cx="5715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7468F5E9-CA24-D040-6F58-AE95A83E5D4A}"/>
              </a:ext>
            </a:extLst>
          </p:cNvPr>
          <p:cNvCxnSpPr>
            <a:cxnSpLocks/>
          </p:cNvCxnSpPr>
          <p:nvPr/>
        </p:nvCxnSpPr>
        <p:spPr>
          <a:xfrm>
            <a:off x="5168367" y="2776912"/>
            <a:ext cx="5715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623E4554-97F6-A8E9-569C-EDA34F0B0FA7}"/>
              </a:ext>
            </a:extLst>
          </p:cNvPr>
          <p:cNvCxnSpPr>
            <a:cxnSpLocks/>
          </p:cNvCxnSpPr>
          <p:nvPr/>
        </p:nvCxnSpPr>
        <p:spPr>
          <a:xfrm>
            <a:off x="7958138" y="2786063"/>
            <a:ext cx="5715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1EC9339-FA6C-B47F-6BBD-4352DD599337}"/>
              </a:ext>
            </a:extLst>
          </p:cNvPr>
          <p:cNvSpPr txBox="1"/>
          <p:nvPr/>
        </p:nvSpPr>
        <p:spPr>
          <a:xfrm>
            <a:off x="666100" y="3242344"/>
            <a:ext cx="524525" cy="369332"/>
          </a:xfrm>
          <a:prstGeom prst="rect">
            <a:avLst/>
          </a:prstGeom>
          <a:solidFill>
            <a:schemeClr val="bg1">
              <a:alpha val="5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b)</a:t>
            </a:r>
            <a:endParaRPr kumimoji="1" lang="ja-JP" altLang="en-US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E4291FF-07E3-9AE9-60A4-18E946A87413}"/>
              </a:ext>
            </a:extLst>
          </p:cNvPr>
          <p:cNvSpPr txBox="1"/>
          <p:nvPr/>
        </p:nvSpPr>
        <p:spPr>
          <a:xfrm>
            <a:off x="3395007" y="3233757"/>
            <a:ext cx="524524" cy="369332"/>
          </a:xfrm>
          <a:prstGeom prst="rect">
            <a:avLst/>
          </a:prstGeom>
          <a:solidFill>
            <a:schemeClr val="bg1">
              <a:alpha val="5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d)</a:t>
            </a:r>
            <a:endParaRPr kumimoji="1" lang="ja-JP" altLang="en-US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E828AA6-7DAC-ED68-363A-2A1CEDB007F8}"/>
              </a:ext>
            </a:extLst>
          </p:cNvPr>
          <p:cNvSpPr txBox="1"/>
          <p:nvPr/>
        </p:nvSpPr>
        <p:spPr>
          <a:xfrm>
            <a:off x="3357967" y="1235328"/>
            <a:ext cx="524525" cy="369332"/>
          </a:xfrm>
          <a:prstGeom prst="rect">
            <a:avLst/>
          </a:prstGeom>
          <a:solidFill>
            <a:schemeClr val="bg1">
              <a:alpha val="5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c)</a:t>
            </a:r>
            <a:endParaRPr kumimoji="1" lang="ja-JP" altLang="en-US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35DF501-C84E-588A-B833-B85B58C6185B}"/>
              </a:ext>
            </a:extLst>
          </p:cNvPr>
          <p:cNvSpPr txBox="1"/>
          <p:nvPr/>
        </p:nvSpPr>
        <p:spPr>
          <a:xfrm>
            <a:off x="6068171" y="1232951"/>
            <a:ext cx="524525" cy="369332"/>
          </a:xfrm>
          <a:prstGeom prst="rect">
            <a:avLst/>
          </a:prstGeom>
          <a:solidFill>
            <a:schemeClr val="bg1">
              <a:alpha val="5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e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144430698"/>
      </p:ext>
    </p:extLst>
  </p:cSld>
  <p:clrMapOvr>
    <a:masterClrMapping/>
  </p:clrMapOvr>
</p:sld>
</file>

<file path=ppt/theme/theme1.xml><?xml version="1.0" encoding="utf-8"?>
<a:theme xmlns:a="http://schemas.openxmlformats.org/drawingml/2006/main" name="テーマ1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 rtlCol="0" anchor="ctr"/>
      <a:lstStyle>
        <a:defPPr algn="ctr">
          <a:defRPr kumimoji="1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テーマ1" id="{493BB3EC-0BC4-40F4-9661-E0ABE417DE37}" vid="{B8B79136-B247-4409-91B3-17953E72BC6B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32234</TotalTime>
  <Words>362</Words>
  <Application>Microsoft Office PowerPoint</Application>
  <PresentationFormat>画面に合わせる (4:3)</PresentationFormat>
  <Paragraphs>45</Paragraphs>
  <Slides>6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2" baseType="lpstr">
      <vt:lpstr>游ゴシック</vt:lpstr>
      <vt:lpstr>Arial</vt:lpstr>
      <vt:lpstr>Calibri</vt:lpstr>
      <vt:lpstr>Calibri Light</vt:lpstr>
      <vt:lpstr>テーマ1</vt:lpstr>
      <vt:lpstr>Prism 9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tsushi</dc:creator>
  <cp:lastModifiedBy>馬原　淳</cp:lastModifiedBy>
  <cp:revision>199</cp:revision>
  <cp:lastPrinted>2023-03-07T00:30:02Z</cp:lastPrinted>
  <dcterms:created xsi:type="dcterms:W3CDTF">2015-02-09T03:38:53Z</dcterms:created>
  <dcterms:modified xsi:type="dcterms:W3CDTF">2023-10-17T14:40:38Z</dcterms:modified>
</cp:coreProperties>
</file>